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9" r:id="rId3"/>
    <p:sldId id="258" r:id="rId4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2" autoAdjust="0"/>
    <p:restoredTop sz="94660"/>
  </p:normalViewPr>
  <p:slideViewPr>
    <p:cSldViewPr snapToGrid="0">
      <p:cViewPr varScale="1">
        <p:scale>
          <a:sx n="83" d="100"/>
          <a:sy n="83" d="100"/>
        </p:scale>
        <p:origin x="389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Downloads\PICRUSt2_result_Sum_190515%20(3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Downloads\PICRUSt2_result_Sum_190515%20(3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Downloads\PICRUSt2_result_Sum_190515%20(3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Downloads\PICRUSt2_result_Sum_190515%20(3)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Downloads\PICRUSt2_result_Sum_190515%20(3)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Owner\Downloads\PICRUSt2_result_Sum_190515%20(3)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662010701223333"/>
          <c:y val="2.2223269315166518E-2"/>
          <c:w val="0.83824198631658231"/>
          <c:h val="0.6130459085332413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PICRUSt2_result_Sum_190515 (3).xlsx]T&amp;G_C_N_P_S'!$B$102</c:f>
              <c:strCache>
                <c:ptCount val="1"/>
                <c:pt idx="0">
                  <c:v>E.versico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O$103:$O$109</c:f>
                <c:numCache>
                  <c:formatCode>General</c:formatCode>
                  <c:ptCount val="7"/>
                  <c:pt idx="0">
                    <c:v>8.2226769821899994E-3</c:v>
                  </c:pt>
                  <c:pt idx="1">
                    <c:v>8.5124426169799997E-2</c:v>
                  </c:pt>
                  <c:pt idx="2">
                    <c:v>0.15877278228399999</c:v>
                  </c:pt>
                  <c:pt idx="3">
                    <c:v>6.2492989327199997E-3</c:v>
                  </c:pt>
                  <c:pt idx="4">
                    <c:v>0.11175093458</c:v>
                  </c:pt>
                  <c:pt idx="5">
                    <c:v>0.144922309868</c:v>
                  </c:pt>
                  <c:pt idx="6">
                    <c:v>4.9160184637199998E-4</c:v>
                  </c:pt>
                </c:numCache>
              </c:numRef>
            </c:plus>
            <c:minus>
              <c:numRef>
                <c:f>'[PICRUSt2_result_Sum_190515 (3).xlsx]T&amp;G_C_N_P_S'!$O$103:$O$109</c:f>
                <c:numCache>
                  <c:formatCode>General</c:formatCode>
                  <c:ptCount val="7"/>
                  <c:pt idx="0">
                    <c:v>8.2226769821899994E-3</c:v>
                  </c:pt>
                  <c:pt idx="1">
                    <c:v>8.5124426169799997E-2</c:v>
                  </c:pt>
                  <c:pt idx="2">
                    <c:v>0.15877278228399999</c:v>
                  </c:pt>
                  <c:pt idx="3">
                    <c:v>6.2492989327199997E-3</c:v>
                  </c:pt>
                  <c:pt idx="4">
                    <c:v>0.11175093458</c:v>
                  </c:pt>
                  <c:pt idx="5">
                    <c:v>0.144922309868</c:v>
                  </c:pt>
                  <c:pt idx="6">
                    <c:v>4.9160184637199998E-4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103:$A$109</c:f>
              <c:strCache>
                <c:ptCount val="7"/>
                <c:pt idx="0">
                  <c:v>cellulose degradation</c:v>
                </c:pt>
                <c:pt idx="1">
                  <c:v>chitin derivatives degradation</c:v>
                </c:pt>
                <c:pt idx="2">
                  <c:v>glycogen degradation I (bacterial)</c:v>
                </c:pt>
                <c:pt idx="3">
                  <c:v>glycogen degradation II (eukaryotic)</c:v>
                </c:pt>
                <c:pt idx="4">
                  <c:v>mannan degradation</c:v>
                </c:pt>
                <c:pt idx="5">
                  <c:v>starch degradation V</c:v>
                </c:pt>
                <c:pt idx="6">
                  <c:v>xylan degradation</c:v>
                </c:pt>
              </c:strCache>
            </c:strRef>
          </c:cat>
          <c:val>
            <c:numRef>
              <c:f>'[PICRUSt2_result_Sum_190515 (3).xlsx]T&amp;G_C_N_P_S'!$B$103:$B$109</c:f>
              <c:numCache>
                <c:formatCode>General</c:formatCode>
                <c:ptCount val="7"/>
                <c:pt idx="0">
                  <c:v>6.5168900605599997E-3</c:v>
                </c:pt>
                <c:pt idx="1">
                  <c:v>0.134397389319</c:v>
                </c:pt>
                <c:pt idx="2">
                  <c:v>0.41374661787</c:v>
                </c:pt>
                <c:pt idx="3">
                  <c:v>5.45398375723E-3</c:v>
                </c:pt>
                <c:pt idx="4">
                  <c:v>0.139406993216</c:v>
                </c:pt>
                <c:pt idx="5">
                  <c:v>0.397027121348</c:v>
                </c:pt>
                <c:pt idx="6">
                  <c:v>2.8382645833700002E-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DF9-4EAD-9E21-F9B571A8EA09}"/>
            </c:ext>
          </c:extLst>
        </c:ser>
        <c:ser>
          <c:idx val="1"/>
          <c:order val="1"/>
          <c:tx>
            <c:strRef>
              <c:f>'[PICRUSt2_result_Sum_190515 (3).xlsx]T&amp;G_C_N_P_S'!$C$102</c:f>
              <c:strCache>
                <c:ptCount val="1"/>
                <c:pt idx="0">
                  <c:v>N.smithi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P$103:$P$109</c:f>
                <c:numCache>
                  <c:formatCode>General</c:formatCode>
                  <c:ptCount val="7"/>
                  <c:pt idx="0">
                    <c:v>4.1172186771300003E-3</c:v>
                  </c:pt>
                  <c:pt idx="1">
                    <c:v>8.98379559602E-3</c:v>
                  </c:pt>
                  <c:pt idx="2">
                    <c:v>4.0064220903300002E-2</c:v>
                  </c:pt>
                  <c:pt idx="3">
                    <c:v>1.10969401833E-2</c:v>
                  </c:pt>
                  <c:pt idx="4">
                    <c:v>6.98969510732E-2</c:v>
                  </c:pt>
                  <c:pt idx="5">
                    <c:v>3.5484536291300002E-2</c:v>
                  </c:pt>
                  <c:pt idx="6">
                    <c:v>4.4916411959599998E-4</c:v>
                  </c:pt>
                </c:numCache>
              </c:numRef>
            </c:plus>
            <c:minus>
              <c:numRef>
                <c:f>'[PICRUSt2_result_Sum_190515 (3).xlsx]T&amp;G_C_N_P_S'!$P$103:$P$109</c:f>
                <c:numCache>
                  <c:formatCode>General</c:formatCode>
                  <c:ptCount val="7"/>
                  <c:pt idx="0">
                    <c:v>4.1172186771300003E-3</c:v>
                  </c:pt>
                  <c:pt idx="1">
                    <c:v>8.98379559602E-3</c:v>
                  </c:pt>
                  <c:pt idx="2">
                    <c:v>4.0064220903300002E-2</c:v>
                  </c:pt>
                  <c:pt idx="3">
                    <c:v>1.10969401833E-2</c:v>
                  </c:pt>
                  <c:pt idx="4">
                    <c:v>6.98969510732E-2</c:v>
                  </c:pt>
                  <c:pt idx="5">
                    <c:v>3.5484536291300002E-2</c:v>
                  </c:pt>
                  <c:pt idx="6">
                    <c:v>4.4916411959599998E-4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103:$A$109</c:f>
              <c:strCache>
                <c:ptCount val="7"/>
                <c:pt idx="0">
                  <c:v>cellulose degradation</c:v>
                </c:pt>
                <c:pt idx="1">
                  <c:v>chitin derivatives degradation</c:v>
                </c:pt>
                <c:pt idx="2">
                  <c:v>glycogen degradation I (bacterial)</c:v>
                </c:pt>
                <c:pt idx="3">
                  <c:v>glycogen degradation II (eukaryotic)</c:v>
                </c:pt>
                <c:pt idx="4">
                  <c:v>mannan degradation</c:v>
                </c:pt>
                <c:pt idx="5">
                  <c:v>starch degradation V</c:v>
                </c:pt>
                <c:pt idx="6">
                  <c:v>xylan degradation</c:v>
                </c:pt>
              </c:strCache>
            </c:strRef>
          </c:cat>
          <c:val>
            <c:numRef>
              <c:f>'[PICRUSt2_result_Sum_190515 (3).xlsx]T&amp;G_C_N_P_S'!$C$103:$C$109</c:f>
              <c:numCache>
                <c:formatCode>General</c:formatCode>
                <c:ptCount val="7"/>
                <c:pt idx="0">
                  <c:v>3.1158625131799999E-3</c:v>
                </c:pt>
                <c:pt idx="1">
                  <c:v>8.3939291858500006E-2</c:v>
                </c:pt>
                <c:pt idx="2">
                  <c:v>0.45944980178799999</c:v>
                </c:pt>
                <c:pt idx="3">
                  <c:v>6.4068214020000002E-3</c:v>
                </c:pt>
                <c:pt idx="4">
                  <c:v>0.16973105909700001</c:v>
                </c:pt>
                <c:pt idx="5">
                  <c:v>0.42436461096400002</c:v>
                </c:pt>
                <c:pt idx="6">
                  <c:v>2.5932502535899998E-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DF9-4EAD-9E21-F9B571A8EA09}"/>
            </c:ext>
          </c:extLst>
        </c:ser>
        <c:ser>
          <c:idx val="2"/>
          <c:order val="2"/>
          <c:tx>
            <c:strRef>
              <c:f>'[PICRUSt2_result_Sum_190515 (3).xlsx]T&amp;G_C_N_P_S'!$D$102</c:f>
              <c:strCache>
                <c:ptCount val="1"/>
                <c:pt idx="0">
                  <c:v>P.indiaru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Q$103:$Q$109</c:f>
                <c:numCache>
                  <c:formatCode>General</c:formatCode>
                  <c:ptCount val="7"/>
                  <c:pt idx="0">
                    <c:v>6.2969121561000001E-3</c:v>
                  </c:pt>
                  <c:pt idx="1">
                    <c:v>2.7914740516699999E-2</c:v>
                  </c:pt>
                  <c:pt idx="2">
                    <c:v>2.90055299717E-2</c:v>
                  </c:pt>
                  <c:pt idx="3">
                    <c:v>8.1496166185699992E-3</c:v>
                  </c:pt>
                  <c:pt idx="4">
                    <c:v>9.2606023875800008E-3</c:v>
                  </c:pt>
                  <c:pt idx="5">
                    <c:v>2.5873520473000001E-2</c:v>
                  </c:pt>
                  <c:pt idx="6">
                    <c:v>0</c:v>
                  </c:pt>
                </c:numCache>
              </c:numRef>
            </c:plus>
            <c:minus>
              <c:numRef>
                <c:f>'[PICRUSt2_result_Sum_190515 (3).xlsx]T&amp;G_C_N_P_S'!$Q$103:$Q$109</c:f>
                <c:numCache>
                  <c:formatCode>General</c:formatCode>
                  <c:ptCount val="7"/>
                  <c:pt idx="0">
                    <c:v>6.2969121561000001E-3</c:v>
                  </c:pt>
                  <c:pt idx="1">
                    <c:v>2.7914740516699999E-2</c:v>
                  </c:pt>
                  <c:pt idx="2">
                    <c:v>2.90055299717E-2</c:v>
                  </c:pt>
                  <c:pt idx="3">
                    <c:v>8.1496166185699992E-3</c:v>
                  </c:pt>
                  <c:pt idx="4">
                    <c:v>9.2606023875800008E-3</c:v>
                  </c:pt>
                  <c:pt idx="5">
                    <c:v>2.5873520473000001E-2</c:v>
                  </c:pt>
                  <c:pt idx="6">
                    <c:v>0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103:$A$109</c:f>
              <c:strCache>
                <c:ptCount val="7"/>
                <c:pt idx="0">
                  <c:v>cellulose degradation</c:v>
                </c:pt>
                <c:pt idx="1">
                  <c:v>chitin derivatives degradation</c:v>
                </c:pt>
                <c:pt idx="2">
                  <c:v>glycogen degradation I (bacterial)</c:v>
                </c:pt>
                <c:pt idx="3">
                  <c:v>glycogen degradation II (eukaryotic)</c:v>
                </c:pt>
                <c:pt idx="4">
                  <c:v>mannan degradation</c:v>
                </c:pt>
                <c:pt idx="5">
                  <c:v>starch degradation V</c:v>
                </c:pt>
                <c:pt idx="6">
                  <c:v>xylan degradation</c:v>
                </c:pt>
              </c:strCache>
            </c:strRef>
          </c:cat>
          <c:val>
            <c:numRef>
              <c:f>'[PICRUSt2_result_Sum_190515 (3).xlsx]T&amp;G_C_N_P_S'!$D$103:$D$109</c:f>
              <c:numCache>
                <c:formatCode>General</c:formatCode>
                <c:ptCount val="7"/>
                <c:pt idx="0">
                  <c:v>9.3428069063799992E-3</c:v>
                </c:pt>
                <c:pt idx="1">
                  <c:v>9.6987156472600006E-2</c:v>
                </c:pt>
                <c:pt idx="2">
                  <c:v>0.28350958114800001</c:v>
                </c:pt>
                <c:pt idx="3">
                  <c:v>1.9280182320500001E-2</c:v>
                </c:pt>
                <c:pt idx="4">
                  <c:v>9.1834787676400003E-3</c:v>
                </c:pt>
                <c:pt idx="5">
                  <c:v>0.27547082869299999</c:v>
                </c:pt>
                <c:pt idx="6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DDF9-4EAD-9E21-F9B571A8EA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1419040"/>
        <c:axId val="241420128"/>
      </c:barChart>
      <c:catAx>
        <c:axId val="2414190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1800000" spcFirstLastPara="1" vertOverflow="ellipsis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41420128"/>
        <c:crosses val="autoZero"/>
        <c:auto val="1"/>
        <c:lblAlgn val="ctr"/>
        <c:lblOffset val="100"/>
        <c:noMultiLvlLbl val="0"/>
      </c:catAx>
      <c:valAx>
        <c:axId val="24142012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414190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 w="6350" cap="flat" cmpd="sng" algn="ctr">
      <a:noFill/>
      <a:prstDash val="solid"/>
      <a:miter lim="800000"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276607569323217"/>
          <c:y val="7.9232983143899913E-2"/>
          <c:w val="0.75818104032445299"/>
          <c:h val="0.64127386764938488"/>
        </c:manualLayout>
      </c:layout>
      <c:barChart>
        <c:barDir val="col"/>
        <c:grouping val="clustered"/>
        <c:varyColors val="0"/>
        <c:ser>
          <c:idx val="4"/>
          <c:order val="0"/>
          <c:tx>
            <c:strRef>
              <c:f>'[PICRUSt2_result_Sum_190515 (3).xlsx]T&amp;G_C_N_P_S'!$F$102</c:f>
              <c:strCache>
                <c:ptCount val="1"/>
                <c:pt idx="0">
                  <c:v>Upper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R$103:$R$109</c:f>
                <c:numCache>
                  <c:formatCode>General</c:formatCode>
                  <c:ptCount val="7"/>
                  <c:pt idx="0">
                    <c:v>1.95061911001E-2</c:v>
                  </c:pt>
                  <c:pt idx="1">
                    <c:v>1.6012222803200001E-3</c:v>
                  </c:pt>
                  <c:pt idx="2">
                    <c:v>1.7813524607699999E-2</c:v>
                  </c:pt>
                  <c:pt idx="3">
                    <c:v>3.0392014024300001E-2</c:v>
                  </c:pt>
                  <c:pt idx="4">
                    <c:v>2.11448926421E-3</c:v>
                  </c:pt>
                  <c:pt idx="5">
                    <c:v>4.6963148750200001E-3</c:v>
                  </c:pt>
                  <c:pt idx="6">
                    <c:v>1.4196265169900001E-3</c:v>
                  </c:pt>
                </c:numCache>
              </c:numRef>
            </c:plus>
            <c:minus>
              <c:numRef>
                <c:f>'[PICRUSt2_result_Sum_190515 (3).xlsx]T&amp;G_C_N_P_S'!$R$103:$R$109</c:f>
                <c:numCache>
                  <c:formatCode>General</c:formatCode>
                  <c:ptCount val="7"/>
                  <c:pt idx="0">
                    <c:v>1.95061911001E-2</c:v>
                  </c:pt>
                  <c:pt idx="1">
                    <c:v>1.6012222803200001E-3</c:v>
                  </c:pt>
                  <c:pt idx="2">
                    <c:v>1.7813524607699999E-2</c:v>
                  </c:pt>
                  <c:pt idx="3">
                    <c:v>3.0392014024300001E-2</c:v>
                  </c:pt>
                  <c:pt idx="4">
                    <c:v>2.11448926421E-3</c:v>
                  </c:pt>
                  <c:pt idx="5">
                    <c:v>4.6963148750200001E-3</c:v>
                  </c:pt>
                  <c:pt idx="6">
                    <c:v>1.4196265169900001E-3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103:$A$109</c:f>
              <c:strCache>
                <c:ptCount val="7"/>
                <c:pt idx="0">
                  <c:v>cellulose degradation</c:v>
                </c:pt>
                <c:pt idx="1">
                  <c:v>chitin derivatives degradation</c:v>
                </c:pt>
                <c:pt idx="2">
                  <c:v>glycogen degradation I (bacterial)</c:v>
                </c:pt>
                <c:pt idx="3">
                  <c:v>glycogen degradation II (eukaryotic)</c:v>
                </c:pt>
                <c:pt idx="4">
                  <c:v>mannan degradation</c:v>
                </c:pt>
                <c:pt idx="5">
                  <c:v>starch degradation V</c:v>
                </c:pt>
                <c:pt idx="6">
                  <c:v>xylan degradation</c:v>
                </c:pt>
              </c:strCache>
            </c:strRef>
          </c:cat>
          <c:val>
            <c:numRef>
              <c:f>'[PICRUSt2_result_Sum_190515 (3).xlsx]T&amp;G_C_N_P_S'!$F$103:$F$109</c:f>
              <c:numCache>
                <c:formatCode>General</c:formatCode>
                <c:ptCount val="7"/>
                <c:pt idx="0">
                  <c:v>2.2639569510800001E-2</c:v>
                </c:pt>
                <c:pt idx="1">
                  <c:v>1.0256628445499999E-3</c:v>
                </c:pt>
                <c:pt idx="2">
                  <c:v>0.37186695972799999</c:v>
                </c:pt>
                <c:pt idx="3">
                  <c:v>3.2639436855800001E-2</c:v>
                </c:pt>
                <c:pt idx="4">
                  <c:v>1.7480294594500001E-3</c:v>
                </c:pt>
                <c:pt idx="5">
                  <c:v>0.331815886472</c:v>
                </c:pt>
                <c:pt idx="6">
                  <c:v>8.1962175173499996E-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5EAC-412D-922C-8DD9BD360FD5}"/>
            </c:ext>
          </c:extLst>
        </c:ser>
        <c:ser>
          <c:idx val="5"/>
          <c:order val="1"/>
          <c:tx>
            <c:strRef>
              <c:f>'[PICRUSt2_result_Sum_190515 (3).xlsx]T&amp;G_C_N_P_S'!$G$102</c:f>
              <c:strCache>
                <c:ptCount val="1"/>
                <c:pt idx="0">
                  <c:v>Middle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S$103:$S$109</c:f>
                <c:numCache>
                  <c:formatCode>General</c:formatCode>
                  <c:ptCount val="7"/>
                  <c:pt idx="0">
                    <c:v>1.76976452409E-3</c:v>
                  </c:pt>
                  <c:pt idx="1">
                    <c:v>2.3264233959200001E-3</c:v>
                  </c:pt>
                  <c:pt idx="2">
                    <c:v>5.7158414832099998E-2</c:v>
                  </c:pt>
                  <c:pt idx="3">
                    <c:v>2.3647823680999999E-3</c:v>
                  </c:pt>
                  <c:pt idx="4">
                    <c:v>6.8900263967100004E-3</c:v>
                  </c:pt>
                  <c:pt idx="5">
                    <c:v>3.7330561811400001E-2</c:v>
                  </c:pt>
                  <c:pt idx="6">
                    <c:v>2.8234235269099998E-4</c:v>
                  </c:pt>
                </c:numCache>
              </c:numRef>
            </c:plus>
            <c:minus>
              <c:numRef>
                <c:f>'[PICRUSt2_result_Sum_190515 (3).xlsx]T&amp;G_C_N_P_S'!$S$103:$S$109</c:f>
                <c:numCache>
                  <c:formatCode>General</c:formatCode>
                  <c:ptCount val="7"/>
                  <c:pt idx="0">
                    <c:v>1.76976452409E-3</c:v>
                  </c:pt>
                  <c:pt idx="1">
                    <c:v>2.3264233959200001E-3</c:v>
                  </c:pt>
                  <c:pt idx="2">
                    <c:v>5.7158414832099998E-2</c:v>
                  </c:pt>
                  <c:pt idx="3">
                    <c:v>2.3647823680999999E-3</c:v>
                  </c:pt>
                  <c:pt idx="4">
                    <c:v>6.8900263967100004E-3</c:v>
                  </c:pt>
                  <c:pt idx="5">
                    <c:v>3.7330561811400001E-2</c:v>
                  </c:pt>
                  <c:pt idx="6">
                    <c:v>2.8234235269099998E-4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103:$A$109</c:f>
              <c:strCache>
                <c:ptCount val="7"/>
                <c:pt idx="0">
                  <c:v>cellulose degradation</c:v>
                </c:pt>
                <c:pt idx="1">
                  <c:v>chitin derivatives degradation</c:v>
                </c:pt>
                <c:pt idx="2">
                  <c:v>glycogen degradation I (bacterial)</c:v>
                </c:pt>
                <c:pt idx="3">
                  <c:v>glycogen degradation II (eukaryotic)</c:v>
                </c:pt>
                <c:pt idx="4">
                  <c:v>mannan degradation</c:v>
                </c:pt>
                <c:pt idx="5">
                  <c:v>starch degradation V</c:v>
                </c:pt>
                <c:pt idx="6">
                  <c:v>xylan degradation</c:v>
                </c:pt>
              </c:strCache>
            </c:strRef>
          </c:cat>
          <c:val>
            <c:numRef>
              <c:f>'[PICRUSt2_result_Sum_190515 (3).xlsx]T&amp;G_C_N_P_S'!$G$103:$G$109</c:f>
              <c:numCache>
                <c:formatCode>General</c:formatCode>
                <c:ptCount val="7"/>
                <c:pt idx="0">
                  <c:v>2.3489546535099999E-3</c:v>
                </c:pt>
                <c:pt idx="1">
                  <c:v>2.5560330532299999E-3</c:v>
                </c:pt>
                <c:pt idx="2">
                  <c:v>0.34321347440099997</c:v>
                </c:pt>
                <c:pt idx="3">
                  <c:v>3.6421962143299998E-3</c:v>
                </c:pt>
                <c:pt idx="4">
                  <c:v>1.02705483174E-2</c:v>
                </c:pt>
                <c:pt idx="5">
                  <c:v>0.264480747716</c:v>
                </c:pt>
                <c:pt idx="6">
                  <c:v>1.7509617595299999E-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5EAC-412D-922C-8DD9BD360FD5}"/>
            </c:ext>
          </c:extLst>
        </c:ser>
        <c:ser>
          <c:idx val="6"/>
          <c:order val="2"/>
          <c:tx>
            <c:strRef>
              <c:f>'[PICRUSt2_result_Sum_190515 (3).xlsx]T&amp;G_C_N_P_S'!$H$102</c:f>
              <c:strCache>
                <c:ptCount val="1"/>
                <c:pt idx="0">
                  <c:v>Lower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T$103:$T$109</c:f>
                <c:numCache>
                  <c:formatCode>General</c:formatCode>
                  <c:ptCount val="7"/>
                  <c:pt idx="0">
                    <c:v>7.7002235424499998E-3</c:v>
                  </c:pt>
                  <c:pt idx="1">
                    <c:v>1.7100902439100001E-3</c:v>
                  </c:pt>
                  <c:pt idx="2">
                    <c:v>4.2329048724799999E-2</c:v>
                  </c:pt>
                  <c:pt idx="3">
                    <c:v>7.4811340911699999E-3</c:v>
                  </c:pt>
                  <c:pt idx="4">
                    <c:v>1.24550805027E-2</c:v>
                  </c:pt>
                  <c:pt idx="5">
                    <c:v>5.8365743169999998E-2</c:v>
                  </c:pt>
                  <c:pt idx="6">
                    <c:v>1.1087625589E-3</c:v>
                  </c:pt>
                </c:numCache>
              </c:numRef>
            </c:plus>
            <c:minus>
              <c:numRef>
                <c:f>'[PICRUSt2_result_Sum_190515 (3).xlsx]T&amp;G_C_N_P_S'!$T$103:$T$109</c:f>
                <c:numCache>
                  <c:formatCode>General</c:formatCode>
                  <c:ptCount val="7"/>
                  <c:pt idx="0">
                    <c:v>7.7002235424499998E-3</c:v>
                  </c:pt>
                  <c:pt idx="1">
                    <c:v>1.7100902439100001E-3</c:v>
                  </c:pt>
                  <c:pt idx="2">
                    <c:v>4.2329048724799999E-2</c:v>
                  </c:pt>
                  <c:pt idx="3">
                    <c:v>7.4811340911699999E-3</c:v>
                  </c:pt>
                  <c:pt idx="4">
                    <c:v>1.24550805027E-2</c:v>
                  </c:pt>
                  <c:pt idx="5">
                    <c:v>5.8365743169999998E-2</c:v>
                  </c:pt>
                  <c:pt idx="6">
                    <c:v>1.1087625589E-3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103:$A$109</c:f>
              <c:strCache>
                <c:ptCount val="7"/>
                <c:pt idx="0">
                  <c:v>cellulose degradation</c:v>
                </c:pt>
                <c:pt idx="1">
                  <c:v>chitin derivatives degradation</c:v>
                </c:pt>
                <c:pt idx="2">
                  <c:v>glycogen degradation I (bacterial)</c:v>
                </c:pt>
                <c:pt idx="3">
                  <c:v>glycogen degradation II (eukaryotic)</c:v>
                </c:pt>
                <c:pt idx="4">
                  <c:v>mannan degradation</c:v>
                </c:pt>
                <c:pt idx="5">
                  <c:v>starch degradation V</c:v>
                </c:pt>
                <c:pt idx="6">
                  <c:v>xylan degradation</c:v>
                </c:pt>
              </c:strCache>
            </c:strRef>
          </c:cat>
          <c:val>
            <c:numRef>
              <c:f>'[PICRUSt2_result_Sum_190515 (3).xlsx]T&amp;G_C_N_P_S'!$H$103:$H$109</c:f>
              <c:numCache>
                <c:formatCode>General</c:formatCode>
                <c:ptCount val="7"/>
                <c:pt idx="0">
                  <c:v>6.4448115756700003E-3</c:v>
                </c:pt>
                <c:pt idx="1">
                  <c:v>1.58545222745E-3</c:v>
                </c:pt>
                <c:pt idx="2">
                  <c:v>0.38128077185199999</c:v>
                </c:pt>
                <c:pt idx="3">
                  <c:v>8.95704055492E-3</c:v>
                </c:pt>
                <c:pt idx="4">
                  <c:v>9.9102002797899994E-3</c:v>
                </c:pt>
                <c:pt idx="5">
                  <c:v>0.32566020066500001</c:v>
                </c:pt>
                <c:pt idx="6">
                  <c:v>6.81969747247E-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5EAC-412D-922C-8DD9BD360FD5}"/>
            </c:ext>
          </c:extLst>
        </c:ser>
        <c:ser>
          <c:idx val="7"/>
          <c:order val="3"/>
          <c:tx>
            <c:strRef>
              <c:f>'[PICRUSt2_result_Sum_190515 (3).xlsx]T&amp;G_C_N_P_S'!$I$102</c:f>
              <c:strCache>
                <c:ptCount val="1"/>
                <c:pt idx="0">
                  <c:v>Digged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U$103:$U$109</c:f>
                <c:numCache>
                  <c:formatCode>General</c:formatCode>
                  <c:ptCount val="7"/>
                  <c:pt idx="0">
                    <c:v>2.0593181444800001E-3</c:v>
                  </c:pt>
                  <c:pt idx="1">
                    <c:v>1.2915322149099999E-3</c:v>
                  </c:pt>
                  <c:pt idx="2">
                    <c:v>5.2911546202199997E-2</c:v>
                  </c:pt>
                  <c:pt idx="3">
                    <c:v>1.06318803602E-3</c:v>
                  </c:pt>
                  <c:pt idx="4">
                    <c:v>7.1970353607500002E-3</c:v>
                  </c:pt>
                  <c:pt idx="5">
                    <c:v>2.98114371169E-2</c:v>
                  </c:pt>
                  <c:pt idx="6">
                    <c:v>4.08432861129E-4</c:v>
                  </c:pt>
                </c:numCache>
              </c:numRef>
            </c:plus>
            <c:minus>
              <c:numRef>
                <c:f>'[PICRUSt2_result_Sum_190515 (3).xlsx]T&amp;G_C_N_P_S'!$U$103:$U$109</c:f>
                <c:numCache>
                  <c:formatCode>General</c:formatCode>
                  <c:ptCount val="7"/>
                  <c:pt idx="0">
                    <c:v>2.0593181444800001E-3</c:v>
                  </c:pt>
                  <c:pt idx="1">
                    <c:v>1.2915322149099999E-3</c:v>
                  </c:pt>
                  <c:pt idx="2">
                    <c:v>5.2911546202199997E-2</c:v>
                  </c:pt>
                  <c:pt idx="3">
                    <c:v>1.06318803602E-3</c:v>
                  </c:pt>
                  <c:pt idx="4">
                    <c:v>7.1970353607500002E-3</c:v>
                  </c:pt>
                  <c:pt idx="5">
                    <c:v>2.98114371169E-2</c:v>
                  </c:pt>
                  <c:pt idx="6">
                    <c:v>4.08432861129E-4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103:$A$109</c:f>
              <c:strCache>
                <c:ptCount val="7"/>
                <c:pt idx="0">
                  <c:v>cellulose degradation</c:v>
                </c:pt>
                <c:pt idx="1">
                  <c:v>chitin derivatives degradation</c:v>
                </c:pt>
                <c:pt idx="2">
                  <c:v>glycogen degradation I (bacterial)</c:v>
                </c:pt>
                <c:pt idx="3">
                  <c:v>glycogen degradation II (eukaryotic)</c:v>
                </c:pt>
                <c:pt idx="4">
                  <c:v>mannan degradation</c:v>
                </c:pt>
                <c:pt idx="5">
                  <c:v>starch degradation V</c:v>
                </c:pt>
                <c:pt idx="6">
                  <c:v>xylan degradation</c:v>
                </c:pt>
              </c:strCache>
            </c:strRef>
          </c:cat>
          <c:val>
            <c:numRef>
              <c:f>'[PICRUSt2_result_Sum_190515 (3).xlsx]T&amp;G_C_N_P_S'!$I$103:$I$109</c:f>
              <c:numCache>
                <c:formatCode>General</c:formatCode>
                <c:ptCount val="7"/>
                <c:pt idx="0">
                  <c:v>8.5288561797599999E-3</c:v>
                </c:pt>
                <c:pt idx="1">
                  <c:v>1.79425307038E-3</c:v>
                </c:pt>
                <c:pt idx="2">
                  <c:v>0.36584653756800001</c:v>
                </c:pt>
                <c:pt idx="3">
                  <c:v>1.74890704389E-3</c:v>
                </c:pt>
                <c:pt idx="4">
                  <c:v>9.9062573706699998E-3</c:v>
                </c:pt>
                <c:pt idx="5">
                  <c:v>0.30258976637500001</c:v>
                </c:pt>
                <c:pt idx="6">
                  <c:v>5.0045355155599997E-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7-5EAC-412D-922C-8DD9BD360FD5}"/>
            </c:ext>
          </c:extLst>
        </c:ser>
        <c:ser>
          <c:idx val="8"/>
          <c:order val="4"/>
          <c:tx>
            <c:strRef>
              <c:f>'[PICRUSt2_result_Sum_190515 (3).xlsx]T&amp;G_C_N_P_S'!$J$102</c:f>
              <c:strCache>
                <c:ptCount val="1"/>
                <c:pt idx="0">
                  <c:v>Nest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V$103:$V$109</c:f>
                <c:numCache>
                  <c:formatCode>General</c:formatCode>
                  <c:ptCount val="7"/>
                  <c:pt idx="0">
                    <c:v>2.4834755853599998E-3</c:v>
                  </c:pt>
                  <c:pt idx="1">
                    <c:v>4.3971419842000004E-3</c:v>
                  </c:pt>
                  <c:pt idx="2">
                    <c:v>7.0271653887400004E-2</c:v>
                  </c:pt>
                  <c:pt idx="3">
                    <c:v>7.2232406921799996E-3</c:v>
                  </c:pt>
                  <c:pt idx="4">
                    <c:v>5.2245971678399998E-3</c:v>
                  </c:pt>
                  <c:pt idx="5">
                    <c:v>5.1592069799400002E-2</c:v>
                  </c:pt>
                  <c:pt idx="6">
                    <c:v>8.6650579664399995E-4</c:v>
                  </c:pt>
                </c:numCache>
              </c:numRef>
            </c:plus>
            <c:minus>
              <c:numRef>
                <c:f>'[PICRUSt2_result_Sum_190515 (3).xlsx]T&amp;G_C_N_P_S'!$V$103:$V$109</c:f>
                <c:numCache>
                  <c:formatCode>General</c:formatCode>
                  <c:ptCount val="7"/>
                  <c:pt idx="0">
                    <c:v>2.4834755853599998E-3</c:v>
                  </c:pt>
                  <c:pt idx="1">
                    <c:v>4.3971419842000004E-3</c:v>
                  </c:pt>
                  <c:pt idx="2">
                    <c:v>7.0271653887400004E-2</c:v>
                  </c:pt>
                  <c:pt idx="3">
                    <c:v>7.2232406921799996E-3</c:v>
                  </c:pt>
                  <c:pt idx="4">
                    <c:v>5.2245971678399998E-3</c:v>
                  </c:pt>
                  <c:pt idx="5">
                    <c:v>5.1592069799400002E-2</c:v>
                  </c:pt>
                  <c:pt idx="6">
                    <c:v>8.6650579664399995E-4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103:$A$109</c:f>
              <c:strCache>
                <c:ptCount val="7"/>
                <c:pt idx="0">
                  <c:v>cellulose degradation</c:v>
                </c:pt>
                <c:pt idx="1">
                  <c:v>chitin derivatives degradation</c:v>
                </c:pt>
                <c:pt idx="2">
                  <c:v>glycogen degradation I (bacterial)</c:v>
                </c:pt>
                <c:pt idx="3">
                  <c:v>glycogen degradation II (eukaryotic)</c:v>
                </c:pt>
                <c:pt idx="4">
                  <c:v>mannan degradation</c:v>
                </c:pt>
                <c:pt idx="5">
                  <c:v>starch degradation V</c:v>
                </c:pt>
                <c:pt idx="6">
                  <c:v>xylan degradation</c:v>
                </c:pt>
              </c:strCache>
            </c:strRef>
          </c:cat>
          <c:val>
            <c:numRef>
              <c:f>'[PICRUSt2_result_Sum_190515 (3).xlsx]T&amp;G_C_N_P_S'!$J$103:$J$109</c:f>
              <c:numCache>
                <c:formatCode>General</c:formatCode>
                <c:ptCount val="7"/>
                <c:pt idx="0">
                  <c:v>1.5635198764600001E-2</c:v>
                </c:pt>
                <c:pt idx="1">
                  <c:v>6.0292636146299997E-3</c:v>
                </c:pt>
                <c:pt idx="2">
                  <c:v>0.36802095225600001</c:v>
                </c:pt>
                <c:pt idx="3">
                  <c:v>5.10760247558E-3</c:v>
                </c:pt>
                <c:pt idx="4">
                  <c:v>3.6943480863500001E-3</c:v>
                </c:pt>
                <c:pt idx="5">
                  <c:v>0.32797156217000001</c:v>
                </c:pt>
                <c:pt idx="6">
                  <c:v>6.1271212474499999E-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5EAC-412D-922C-8DD9BD360F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1419584"/>
        <c:axId val="241422304"/>
      </c:barChart>
      <c:catAx>
        <c:axId val="2414195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1800000" spcFirstLastPara="1" vertOverflow="ellipsis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41422304"/>
        <c:crosses val="autoZero"/>
        <c:auto val="1"/>
        <c:lblAlgn val="ctr"/>
        <c:lblOffset val="100"/>
        <c:noMultiLvlLbl val="0"/>
      </c:catAx>
      <c:valAx>
        <c:axId val="24142230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414195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77232570102775178"/>
          <c:y val="2.252801589378129E-2"/>
          <c:w val="0.10321226096294951"/>
          <c:h val="0.3394768001348133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 w="6350" cap="flat" cmpd="sng" algn="ctr">
      <a:noFill/>
      <a:prstDash val="solid"/>
      <a:miter lim="800000"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2738565621535569E-2"/>
          <c:y val="4.7734337555631612E-2"/>
          <c:w val="0.82113659980228104"/>
          <c:h val="0.4733797405759062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PICRUSt2_result_Sum_190515 (3).xlsx]T&amp;G_C_N_P_S'!$B$301</c:f>
              <c:strCache>
                <c:ptCount val="1"/>
                <c:pt idx="0">
                  <c:v>E.versico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O$302:$O$311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1.53998195202E-2</c:v>
                  </c:pt>
                  <c:pt idx="2">
                    <c:v>9.7315003941100004E-3</c:v>
                  </c:pt>
                  <c:pt idx="3">
                    <c:v>0.10748302408800001</c:v>
                  </c:pt>
                  <c:pt idx="4">
                    <c:v>3.2053790865499997E-2</c:v>
                  </c:pt>
                  <c:pt idx="5">
                    <c:v>7.6954911555600003E-3</c:v>
                  </c:pt>
                  <c:pt idx="6">
                    <c:v>0</c:v>
                  </c:pt>
                  <c:pt idx="7">
                    <c:v>0.34202189579499997</c:v>
                  </c:pt>
                  <c:pt idx="8">
                    <c:v>3.0717935422099999E-2</c:v>
                  </c:pt>
                  <c:pt idx="9">
                    <c:v>5.5396154252500003E-2</c:v>
                  </c:pt>
                </c:numCache>
              </c:numRef>
            </c:plus>
            <c:minus>
              <c:numRef>
                <c:f>'[PICRUSt2_result_Sum_190515 (3).xlsx]T&amp;G_C_N_P_S'!$O$302:$O$311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1.53998195202E-2</c:v>
                  </c:pt>
                  <c:pt idx="2">
                    <c:v>9.7315003941100004E-3</c:v>
                  </c:pt>
                  <c:pt idx="3">
                    <c:v>0.10748302408800001</c:v>
                  </c:pt>
                  <c:pt idx="4">
                    <c:v>3.2053790865499997E-2</c:v>
                  </c:pt>
                  <c:pt idx="5">
                    <c:v>7.6954911555600003E-3</c:v>
                  </c:pt>
                  <c:pt idx="6">
                    <c:v>0</c:v>
                  </c:pt>
                  <c:pt idx="7">
                    <c:v>0.34202189579499997</c:v>
                  </c:pt>
                  <c:pt idx="8">
                    <c:v>3.0717935422099999E-2</c:v>
                  </c:pt>
                  <c:pt idx="9">
                    <c:v>5.5396154252500003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302:$A$311</c:f>
              <c:strCache>
                <c:ptCount val="10"/>
                <c:pt idx="0">
                  <c:v>ammonia oxidation</c:v>
                </c:pt>
                <c:pt idx="1">
                  <c:v>nitrate dependent anaerobic methane oxidation</c:v>
                </c:pt>
                <c:pt idx="2">
                  <c:v>nitrate reduction I (denitrification)</c:v>
                </c:pt>
                <c:pt idx="3">
                  <c:v>nitrate reduction IV</c:v>
                </c:pt>
                <c:pt idx="4">
                  <c:v>nitrate reduction IX</c:v>
                </c:pt>
                <c:pt idx="5">
                  <c:v>nitrate reduction VI (assimilatory)</c:v>
                </c:pt>
                <c:pt idx="6">
                  <c:v>nitrifier denitrification</c:v>
                </c:pt>
                <c:pt idx="7">
                  <c:v>nitrogen fixation I+II</c:v>
                </c:pt>
                <c:pt idx="8">
                  <c:v>superpathway of taurine degradation</c:v>
                </c:pt>
                <c:pt idx="9">
                  <c:v>urea cycle</c:v>
                </c:pt>
              </c:strCache>
            </c:strRef>
          </c:cat>
          <c:val>
            <c:numRef>
              <c:f>'[PICRUSt2_result_Sum_190515 (3).xlsx]T&amp;G_C_N_P_S'!$B$302:$B$311</c:f>
              <c:numCache>
                <c:formatCode>General</c:formatCode>
                <c:ptCount val="10"/>
                <c:pt idx="0">
                  <c:v>0</c:v>
                </c:pt>
                <c:pt idx="1">
                  <c:v>1.0822358803E-2</c:v>
                </c:pt>
                <c:pt idx="2">
                  <c:v>8.2822822458800006E-3</c:v>
                </c:pt>
                <c:pt idx="3">
                  <c:v>0.196083527363</c:v>
                </c:pt>
                <c:pt idx="4">
                  <c:v>0.34004182761000001</c:v>
                </c:pt>
                <c:pt idx="5">
                  <c:v>3.9915176814400002E-2</c:v>
                </c:pt>
                <c:pt idx="6">
                  <c:v>0</c:v>
                </c:pt>
                <c:pt idx="7">
                  <c:v>0.25550692118500001</c:v>
                </c:pt>
                <c:pt idx="8">
                  <c:v>2.8767961421899999E-2</c:v>
                </c:pt>
                <c:pt idx="9">
                  <c:v>8.0412907034699999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0FB-4189-9071-5C5ED996E137}"/>
            </c:ext>
          </c:extLst>
        </c:ser>
        <c:ser>
          <c:idx val="1"/>
          <c:order val="1"/>
          <c:tx>
            <c:strRef>
              <c:f>'[PICRUSt2_result_Sum_190515 (3).xlsx]T&amp;G_C_N_P_S'!$C$301</c:f>
              <c:strCache>
                <c:ptCount val="1"/>
                <c:pt idx="0">
                  <c:v>N.smithi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P$302:$P$311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5.3278195738300001E-3</c:v>
                  </c:pt>
                  <c:pt idx="2">
                    <c:v>7.3986766716500002E-3</c:v>
                  </c:pt>
                  <c:pt idx="3">
                    <c:v>8.4491611176199993E-2</c:v>
                  </c:pt>
                  <c:pt idx="4">
                    <c:v>2.6128802952099999E-2</c:v>
                  </c:pt>
                  <c:pt idx="5">
                    <c:v>9.9678696992299993E-3</c:v>
                  </c:pt>
                  <c:pt idx="6">
                    <c:v>0</c:v>
                  </c:pt>
                  <c:pt idx="7">
                    <c:v>0.189198802049</c:v>
                  </c:pt>
                  <c:pt idx="8">
                    <c:v>1.1870720549099999E-2</c:v>
                  </c:pt>
                  <c:pt idx="9">
                    <c:v>3.2410218962500001E-2</c:v>
                  </c:pt>
                </c:numCache>
              </c:numRef>
            </c:plus>
            <c:minus>
              <c:numRef>
                <c:f>'[PICRUSt2_result_Sum_190515 (3).xlsx]T&amp;G_C_N_P_S'!$P$302:$P$311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5.3278195738300001E-3</c:v>
                  </c:pt>
                  <c:pt idx="2">
                    <c:v>7.3986766716500002E-3</c:v>
                  </c:pt>
                  <c:pt idx="3">
                    <c:v>8.4491611176199993E-2</c:v>
                  </c:pt>
                  <c:pt idx="4">
                    <c:v>2.6128802952099999E-2</c:v>
                  </c:pt>
                  <c:pt idx="5">
                    <c:v>9.9678696992299993E-3</c:v>
                  </c:pt>
                  <c:pt idx="6">
                    <c:v>0</c:v>
                  </c:pt>
                  <c:pt idx="7">
                    <c:v>0.189198802049</c:v>
                  </c:pt>
                  <c:pt idx="8">
                    <c:v>1.1870720549099999E-2</c:v>
                  </c:pt>
                  <c:pt idx="9">
                    <c:v>3.2410218962500001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302:$A$311</c:f>
              <c:strCache>
                <c:ptCount val="10"/>
                <c:pt idx="0">
                  <c:v>ammonia oxidation</c:v>
                </c:pt>
                <c:pt idx="1">
                  <c:v>nitrate dependent anaerobic methane oxidation</c:v>
                </c:pt>
                <c:pt idx="2">
                  <c:v>nitrate reduction I (denitrification)</c:v>
                </c:pt>
                <c:pt idx="3">
                  <c:v>nitrate reduction IV</c:v>
                </c:pt>
                <c:pt idx="4">
                  <c:v>nitrate reduction IX</c:v>
                </c:pt>
                <c:pt idx="5">
                  <c:v>nitrate reduction VI (assimilatory)</c:v>
                </c:pt>
                <c:pt idx="6">
                  <c:v>nitrifier denitrification</c:v>
                </c:pt>
                <c:pt idx="7">
                  <c:v>nitrogen fixation I+II</c:v>
                </c:pt>
                <c:pt idx="8">
                  <c:v>superpathway of taurine degradation</c:v>
                </c:pt>
                <c:pt idx="9">
                  <c:v>urea cycle</c:v>
                </c:pt>
              </c:strCache>
            </c:strRef>
          </c:cat>
          <c:val>
            <c:numRef>
              <c:f>'[PICRUSt2_result_Sum_190515 (3).xlsx]T&amp;G_C_N_P_S'!$C$302:$C$311</c:f>
              <c:numCache>
                <c:formatCode>General</c:formatCode>
                <c:ptCount val="10"/>
                <c:pt idx="0">
                  <c:v>0</c:v>
                </c:pt>
                <c:pt idx="1">
                  <c:v>4.8822196569200003E-3</c:v>
                </c:pt>
                <c:pt idx="2">
                  <c:v>6.9425463116099999E-3</c:v>
                </c:pt>
                <c:pt idx="3">
                  <c:v>0.232567536081</c:v>
                </c:pt>
                <c:pt idx="4">
                  <c:v>0.308134727228</c:v>
                </c:pt>
                <c:pt idx="5">
                  <c:v>1.8237944946899998E-2</c:v>
                </c:pt>
                <c:pt idx="6">
                  <c:v>0</c:v>
                </c:pt>
                <c:pt idx="7">
                  <c:v>0.21966047426300001</c:v>
                </c:pt>
                <c:pt idx="8">
                  <c:v>1.44123675763E-2</c:v>
                </c:pt>
                <c:pt idx="9">
                  <c:v>6.5684538067999995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0FB-4189-9071-5C5ED996E137}"/>
            </c:ext>
          </c:extLst>
        </c:ser>
        <c:ser>
          <c:idx val="2"/>
          <c:order val="2"/>
          <c:tx>
            <c:strRef>
              <c:f>'[PICRUSt2_result_Sum_190515 (3).xlsx]T&amp;G_C_N_P_S'!$D$301</c:f>
              <c:strCache>
                <c:ptCount val="1"/>
                <c:pt idx="0">
                  <c:v>P.indiaru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Q$302:$Q$311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7.0167079240799998E-2</c:v>
                  </c:pt>
                  <c:pt idx="2">
                    <c:v>1.5830141071399999E-2</c:v>
                  </c:pt>
                  <c:pt idx="3">
                    <c:v>5.8400818537599999E-2</c:v>
                  </c:pt>
                  <c:pt idx="4">
                    <c:v>6.3589840981799997E-2</c:v>
                  </c:pt>
                  <c:pt idx="5">
                    <c:v>3.5347235408700002E-2</c:v>
                  </c:pt>
                  <c:pt idx="6">
                    <c:v>0</c:v>
                  </c:pt>
                  <c:pt idx="7">
                    <c:v>8.6685944048599996E-3</c:v>
                  </c:pt>
                  <c:pt idx="8">
                    <c:v>2.5469111757899999E-2</c:v>
                  </c:pt>
                  <c:pt idx="9">
                    <c:v>6.3943563237799997E-2</c:v>
                  </c:pt>
                </c:numCache>
              </c:numRef>
            </c:plus>
            <c:minus>
              <c:numRef>
                <c:f>'[PICRUSt2_result_Sum_190515 (3).xlsx]T&amp;G_C_N_P_S'!$Q$302:$Q$311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7.0167079240799998E-2</c:v>
                  </c:pt>
                  <c:pt idx="2">
                    <c:v>1.5830141071399999E-2</c:v>
                  </c:pt>
                  <c:pt idx="3">
                    <c:v>5.8400818537599999E-2</c:v>
                  </c:pt>
                  <c:pt idx="4">
                    <c:v>6.3589840981799997E-2</c:v>
                  </c:pt>
                  <c:pt idx="5">
                    <c:v>3.5347235408700002E-2</c:v>
                  </c:pt>
                  <c:pt idx="6">
                    <c:v>0</c:v>
                  </c:pt>
                  <c:pt idx="7">
                    <c:v>8.6685944048599996E-3</c:v>
                  </c:pt>
                  <c:pt idx="8">
                    <c:v>2.5469111757899999E-2</c:v>
                  </c:pt>
                  <c:pt idx="9">
                    <c:v>6.3943563237799997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302:$A$311</c:f>
              <c:strCache>
                <c:ptCount val="10"/>
                <c:pt idx="0">
                  <c:v>ammonia oxidation</c:v>
                </c:pt>
                <c:pt idx="1">
                  <c:v>nitrate dependent anaerobic methane oxidation</c:v>
                </c:pt>
                <c:pt idx="2">
                  <c:v>nitrate reduction I (denitrification)</c:v>
                </c:pt>
                <c:pt idx="3">
                  <c:v>nitrate reduction IV</c:v>
                </c:pt>
                <c:pt idx="4">
                  <c:v>nitrate reduction IX</c:v>
                </c:pt>
                <c:pt idx="5">
                  <c:v>nitrate reduction VI (assimilatory)</c:v>
                </c:pt>
                <c:pt idx="6">
                  <c:v>nitrifier denitrification</c:v>
                </c:pt>
                <c:pt idx="7">
                  <c:v>nitrogen fixation I+II</c:v>
                </c:pt>
                <c:pt idx="8">
                  <c:v>superpathway of taurine degradation</c:v>
                </c:pt>
                <c:pt idx="9">
                  <c:v>urea cycle</c:v>
                </c:pt>
              </c:strCache>
            </c:strRef>
          </c:cat>
          <c:val>
            <c:numRef>
              <c:f>'[PICRUSt2_result_Sum_190515 (3).xlsx]T&amp;G_C_N_P_S'!$D$302:$D$311</c:f>
              <c:numCache>
                <c:formatCode>General</c:formatCode>
                <c:ptCount val="10"/>
                <c:pt idx="0">
                  <c:v>0</c:v>
                </c:pt>
                <c:pt idx="1">
                  <c:v>6.3995185586099998E-2</c:v>
                </c:pt>
                <c:pt idx="2">
                  <c:v>2.7186983255500001E-2</c:v>
                </c:pt>
                <c:pt idx="3">
                  <c:v>0.133482939292</c:v>
                </c:pt>
                <c:pt idx="4">
                  <c:v>0.40821148983900002</c:v>
                </c:pt>
                <c:pt idx="5">
                  <c:v>5.42568214359E-2</c:v>
                </c:pt>
                <c:pt idx="6">
                  <c:v>0</c:v>
                </c:pt>
                <c:pt idx="7">
                  <c:v>6.2458545343500003E-3</c:v>
                </c:pt>
                <c:pt idx="8">
                  <c:v>4.23983316198E-2</c:v>
                </c:pt>
                <c:pt idx="9">
                  <c:v>0.197138867540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C0FB-4189-9071-5C5ED996E1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1424480"/>
        <c:axId val="241418496"/>
      </c:barChart>
      <c:catAx>
        <c:axId val="2414244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1800000" spcFirstLastPara="1" vertOverflow="ellipsis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41418496"/>
        <c:crosses val="autoZero"/>
        <c:auto val="1"/>
        <c:lblAlgn val="ctr"/>
        <c:lblOffset val="100"/>
        <c:noMultiLvlLbl val="0"/>
      </c:catAx>
      <c:valAx>
        <c:axId val="24141849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414244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 w="6350" cap="flat" cmpd="sng" algn="ctr">
      <a:noFill/>
      <a:prstDash val="solid"/>
      <a:miter lim="800000"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4"/>
          <c:order val="0"/>
          <c:tx>
            <c:strRef>
              <c:f>'[PICRUSt2_result_Sum_190515 (3).xlsx]T&amp;G_C_N_P_S'!$F$301</c:f>
              <c:strCache>
                <c:ptCount val="1"/>
                <c:pt idx="0">
                  <c:v>Upper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R$302:$R$311</c:f>
                <c:numCache>
                  <c:formatCode>General</c:formatCode>
                  <c:ptCount val="10"/>
                  <c:pt idx="0">
                    <c:v>5.8725236579400004E-4</c:v>
                  </c:pt>
                  <c:pt idx="1">
                    <c:v>1.9221670186799999E-2</c:v>
                  </c:pt>
                  <c:pt idx="2">
                    <c:v>7.0016984289900004E-3</c:v>
                  </c:pt>
                  <c:pt idx="3">
                    <c:v>1.83914783162E-3</c:v>
                  </c:pt>
                  <c:pt idx="4">
                    <c:v>4.5667274809599999E-2</c:v>
                  </c:pt>
                  <c:pt idx="5">
                    <c:v>7.2410351969199996E-2</c:v>
                  </c:pt>
                  <c:pt idx="6">
                    <c:v>0</c:v>
                  </c:pt>
                  <c:pt idx="7">
                    <c:v>4.93794056579E-2</c:v>
                  </c:pt>
                  <c:pt idx="8">
                    <c:v>5.3141466355000003E-3</c:v>
                  </c:pt>
                  <c:pt idx="9">
                    <c:v>6.1437057824899999E-2</c:v>
                  </c:pt>
                </c:numCache>
              </c:numRef>
            </c:plus>
            <c:minus>
              <c:numRef>
                <c:f>'[PICRUSt2_result_Sum_190515 (3).xlsx]T&amp;G_C_N_P_S'!$R$302:$R$311</c:f>
                <c:numCache>
                  <c:formatCode>General</c:formatCode>
                  <c:ptCount val="10"/>
                  <c:pt idx="0">
                    <c:v>5.8725236579400004E-4</c:v>
                  </c:pt>
                  <c:pt idx="1">
                    <c:v>1.9221670186799999E-2</c:v>
                  </c:pt>
                  <c:pt idx="2">
                    <c:v>7.0016984289900004E-3</c:v>
                  </c:pt>
                  <c:pt idx="3">
                    <c:v>1.83914783162E-3</c:v>
                  </c:pt>
                  <c:pt idx="4">
                    <c:v>4.5667274809599999E-2</c:v>
                  </c:pt>
                  <c:pt idx="5">
                    <c:v>7.2410351969199996E-2</c:v>
                  </c:pt>
                  <c:pt idx="6">
                    <c:v>0</c:v>
                  </c:pt>
                  <c:pt idx="7">
                    <c:v>4.93794056579E-2</c:v>
                  </c:pt>
                  <c:pt idx="8">
                    <c:v>5.3141466355000003E-3</c:v>
                  </c:pt>
                  <c:pt idx="9">
                    <c:v>6.1437057824899999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302:$A$311</c:f>
              <c:strCache>
                <c:ptCount val="10"/>
                <c:pt idx="0">
                  <c:v>ammonia oxidation</c:v>
                </c:pt>
                <c:pt idx="1">
                  <c:v>nitrate dependent anaerobic methane oxidation</c:v>
                </c:pt>
                <c:pt idx="2">
                  <c:v>nitrate reduction I (denitrification)</c:v>
                </c:pt>
                <c:pt idx="3">
                  <c:v>nitrate reduction IV</c:v>
                </c:pt>
                <c:pt idx="4">
                  <c:v>nitrate reduction IX</c:v>
                </c:pt>
                <c:pt idx="5">
                  <c:v>nitrate reduction VI (assimilatory)</c:v>
                </c:pt>
                <c:pt idx="6">
                  <c:v>nitrifier denitrification</c:v>
                </c:pt>
                <c:pt idx="7">
                  <c:v>nitrogen fixation I+II</c:v>
                </c:pt>
                <c:pt idx="8">
                  <c:v>superpathway of taurine degradation</c:v>
                </c:pt>
                <c:pt idx="9">
                  <c:v>urea cycle</c:v>
                </c:pt>
              </c:strCache>
            </c:strRef>
          </c:cat>
          <c:val>
            <c:numRef>
              <c:f>'[PICRUSt2_result_Sum_190515 (3).xlsx]T&amp;G_C_N_P_S'!$F$302:$F$311</c:f>
              <c:numCache>
                <c:formatCode>General</c:formatCode>
                <c:ptCount val="10"/>
                <c:pt idx="0">
                  <c:v>5.5248838920700003E-4</c:v>
                </c:pt>
                <c:pt idx="1">
                  <c:v>3.4618565608099998E-2</c:v>
                </c:pt>
                <c:pt idx="2">
                  <c:v>1.1343021365100001E-2</c:v>
                </c:pt>
                <c:pt idx="3">
                  <c:v>2.20008754094E-2</c:v>
                </c:pt>
                <c:pt idx="4">
                  <c:v>0.543260060223</c:v>
                </c:pt>
                <c:pt idx="5">
                  <c:v>8.4504481582300006E-2</c:v>
                </c:pt>
                <c:pt idx="6">
                  <c:v>0</c:v>
                </c:pt>
                <c:pt idx="7">
                  <c:v>8.3279278405599996E-2</c:v>
                </c:pt>
                <c:pt idx="8">
                  <c:v>2.04661836503E-2</c:v>
                </c:pt>
                <c:pt idx="9">
                  <c:v>0.174243354959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BDFB-4196-8850-EC092246EE36}"/>
            </c:ext>
          </c:extLst>
        </c:ser>
        <c:ser>
          <c:idx val="5"/>
          <c:order val="1"/>
          <c:tx>
            <c:strRef>
              <c:f>'[PICRUSt2_result_Sum_190515 (3).xlsx]T&amp;G_C_N_P_S'!$G$301</c:f>
              <c:strCache>
                <c:ptCount val="1"/>
                <c:pt idx="0">
                  <c:v>Middle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S$302:$S$311</c:f>
                <c:numCache>
                  <c:formatCode>General</c:formatCode>
                  <c:ptCount val="10"/>
                  <c:pt idx="0">
                    <c:v>7.4309826881600004E-4</c:v>
                  </c:pt>
                  <c:pt idx="1">
                    <c:v>1.1528550896E-2</c:v>
                  </c:pt>
                  <c:pt idx="2">
                    <c:v>3.6844055791599999E-3</c:v>
                  </c:pt>
                  <c:pt idx="3">
                    <c:v>7.5611547333599999E-3</c:v>
                  </c:pt>
                  <c:pt idx="4">
                    <c:v>3.4379427253300003E-2</c:v>
                  </c:pt>
                  <c:pt idx="5">
                    <c:v>5.97846144944E-3</c:v>
                  </c:pt>
                  <c:pt idx="6">
                    <c:v>0</c:v>
                  </c:pt>
                  <c:pt idx="7">
                    <c:v>9.2956290804199995E-2</c:v>
                  </c:pt>
                  <c:pt idx="8">
                    <c:v>1.2064671518299999E-2</c:v>
                  </c:pt>
                  <c:pt idx="9">
                    <c:v>2.0065890925599999E-2</c:v>
                  </c:pt>
                </c:numCache>
              </c:numRef>
            </c:plus>
            <c:minus>
              <c:numRef>
                <c:f>'[PICRUSt2_result_Sum_190515 (3).xlsx]T&amp;G_C_N_P_S'!$S$302:$S$311</c:f>
                <c:numCache>
                  <c:formatCode>General</c:formatCode>
                  <c:ptCount val="10"/>
                  <c:pt idx="0">
                    <c:v>7.4309826881600004E-4</c:v>
                  </c:pt>
                  <c:pt idx="1">
                    <c:v>1.1528550896E-2</c:v>
                  </c:pt>
                  <c:pt idx="2">
                    <c:v>3.6844055791599999E-3</c:v>
                  </c:pt>
                  <c:pt idx="3">
                    <c:v>7.5611547333599999E-3</c:v>
                  </c:pt>
                  <c:pt idx="4">
                    <c:v>3.4379427253300003E-2</c:v>
                  </c:pt>
                  <c:pt idx="5">
                    <c:v>5.97846144944E-3</c:v>
                  </c:pt>
                  <c:pt idx="6">
                    <c:v>0</c:v>
                  </c:pt>
                  <c:pt idx="7">
                    <c:v>9.2956290804199995E-2</c:v>
                  </c:pt>
                  <c:pt idx="8">
                    <c:v>1.2064671518299999E-2</c:v>
                  </c:pt>
                  <c:pt idx="9">
                    <c:v>2.0065890925599999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302:$A$311</c:f>
              <c:strCache>
                <c:ptCount val="10"/>
                <c:pt idx="0">
                  <c:v>ammonia oxidation</c:v>
                </c:pt>
                <c:pt idx="1">
                  <c:v>nitrate dependent anaerobic methane oxidation</c:v>
                </c:pt>
                <c:pt idx="2">
                  <c:v>nitrate reduction I (denitrification)</c:v>
                </c:pt>
                <c:pt idx="3">
                  <c:v>nitrate reduction IV</c:v>
                </c:pt>
                <c:pt idx="4">
                  <c:v>nitrate reduction IX</c:v>
                </c:pt>
                <c:pt idx="5">
                  <c:v>nitrate reduction VI (assimilatory)</c:v>
                </c:pt>
                <c:pt idx="6">
                  <c:v>nitrifier denitrification</c:v>
                </c:pt>
                <c:pt idx="7">
                  <c:v>nitrogen fixation I+II</c:v>
                </c:pt>
                <c:pt idx="8">
                  <c:v>superpathway of taurine degradation</c:v>
                </c:pt>
                <c:pt idx="9">
                  <c:v>urea cycle</c:v>
                </c:pt>
              </c:strCache>
            </c:strRef>
          </c:cat>
          <c:val>
            <c:numRef>
              <c:f>'[PICRUSt2_result_Sum_190515 (3).xlsx]T&amp;G_C_N_P_S'!$G$302:$G$311</c:f>
              <c:numCache>
                <c:formatCode>General</c:formatCode>
                <c:ptCount val="10"/>
                <c:pt idx="0">
                  <c:v>8.83219095764E-4</c:v>
                </c:pt>
                <c:pt idx="1">
                  <c:v>1.2071981126200001E-2</c:v>
                </c:pt>
                <c:pt idx="2">
                  <c:v>7.3616316485999997E-3</c:v>
                </c:pt>
                <c:pt idx="3">
                  <c:v>2.7913883298E-2</c:v>
                </c:pt>
                <c:pt idx="4">
                  <c:v>0.550115008382</c:v>
                </c:pt>
                <c:pt idx="5">
                  <c:v>1.9174598379199999E-2</c:v>
                </c:pt>
                <c:pt idx="6">
                  <c:v>0</c:v>
                </c:pt>
                <c:pt idx="7">
                  <c:v>0.187324716256</c:v>
                </c:pt>
                <c:pt idx="8">
                  <c:v>1.6717536723400001E-2</c:v>
                </c:pt>
                <c:pt idx="9">
                  <c:v>9.6213074684899993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BDFB-4196-8850-EC092246EE36}"/>
            </c:ext>
          </c:extLst>
        </c:ser>
        <c:ser>
          <c:idx val="6"/>
          <c:order val="2"/>
          <c:tx>
            <c:strRef>
              <c:f>'[PICRUSt2_result_Sum_190515 (3).xlsx]T&amp;G_C_N_P_S'!$H$301</c:f>
              <c:strCache>
                <c:ptCount val="1"/>
                <c:pt idx="0">
                  <c:v>Lower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T$302:$T$311</c:f>
                <c:numCache>
                  <c:formatCode>General</c:formatCode>
                  <c:ptCount val="10"/>
                  <c:pt idx="0">
                    <c:v>7.44449550166E-4</c:v>
                  </c:pt>
                  <c:pt idx="1">
                    <c:v>9.0036821153100001E-3</c:v>
                  </c:pt>
                  <c:pt idx="2">
                    <c:v>9.3132931280300001E-3</c:v>
                  </c:pt>
                  <c:pt idx="3">
                    <c:v>1.0559630323799999E-2</c:v>
                  </c:pt>
                  <c:pt idx="4">
                    <c:v>3.4641879294300001E-2</c:v>
                  </c:pt>
                  <c:pt idx="5">
                    <c:v>9.6672823760999994E-3</c:v>
                  </c:pt>
                  <c:pt idx="6">
                    <c:v>3.4961469941800001E-4</c:v>
                  </c:pt>
                  <c:pt idx="7">
                    <c:v>3.8319382665700001E-2</c:v>
                  </c:pt>
                  <c:pt idx="8">
                    <c:v>6.3825941375000002E-3</c:v>
                  </c:pt>
                  <c:pt idx="9">
                    <c:v>1.37696537218E-2</c:v>
                  </c:pt>
                </c:numCache>
              </c:numRef>
            </c:plus>
            <c:minus>
              <c:numRef>
                <c:f>'[PICRUSt2_result_Sum_190515 (3).xlsx]T&amp;G_C_N_P_S'!$T$302:$T$311</c:f>
                <c:numCache>
                  <c:formatCode>General</c:formatCode>
                  <c:ptCount val="10"/>
                  <c:pt idx="0">
                    <c:v>7.44449550166E-4</c:v>
                  </c:pt>
                  <c:pt idx="1">
                    <c:v>9.0036821153100001E-3</c:v>
                  </c:pt>
                  <c:pt idx="2">
                    <c:v>9.3132931280300001E-3</c:v>
                  </c:pt>
                  <c:pt idx="3">
                    <c:v>1.0559630323799999E-2</c:v>
                  </c:pt>
                  <c:pt idx="4">
                    <c:v>3.4641879294300001E-2</c:v>
                  </c:pt>
                  <c:pt idx="5">
                    <c:v>9.6672823760999994E-3</c:v>
                  </c:pt>
                  <c:pt idx="6">
                    <c:v>3.4961469941800001E-4</c:v>
                  </c:pt>
                  <c:pt idx="7">
                    <c:v>3.8319382665700001E-2</c:v>
                  </c:pt>
                  <c:pt idx="8">
                    <c:v>6.3825941375000002E-3</c:v>
                  </c:pt>
                  <c:pt idx="9">
                    <c:v>1.37696537218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302:$A$311</c:f>
              <c:strCache>
                <c:ptCount val="10"/>
                <c:pt idx="0">
                  <c:v>ammonia oxidation</c:v>
                </c:pt>
                <c:pt idx="1">
                  <c:v>nitrate dependent anaerobic methane oxidation</c:v>
                </c:pt>
                <c:pt idx="2">
                  <c:v>nitrate reduction I (denitrification)</c:v>
                </c:pt>
                <c:pt idx="3">
                  <c:v>nitrate reduction IV</c:v>
                </c:pt>
                <c:pt idx="4">
                  <c:v>nitrate reduction IX</c:v>
                </c:pt>
                <c:pt idx="5">
                  <c:v>nitrate reduction VI (assimilatory)</c:v>
                </c:pt>
                <c:pt idx="6">
                  <c:v>nitrifier denitrification</c:v>
                </c:pt>
                <c:pt idx="7">
                  <c:v>nitrogen fixation I+II</c:v>
                </c:pt>
                <c:pt idx="8">
                  <c:v>superpathway of taurine degradation</c:v>
                </c:pt>
                <c:pt idx="9">
                  <c:v>urea cycle</c:v>
                </c:pt>
              </c:strCache>
            </c:strRef>
          </c:cat>
          <c:val>
            <c:numRef>
              <c:f>'[PICRUSt2_result_Sum_190515 (3).xlsx]T&amp;G_C_N_P_S'!$H$302:$H$311</c:f>
              <c:numCache>
                <c:formatCode>General</c:formatCode>
                <c:ptCount val="10"/>
                <c:pt idx="0">
                  <c:v>7.4423425551600004E-4</c:v>
                </c:pt>
                <c:pt idx="1">
                  <c:v>1.6470864030100001E-2</c:v>
                </c:pt>
                <c:pt idx="2">
                  <c:v>9.5940464693199997E-3</c:v>
                </c:pt>
                <c:pt idx="3">
                  <c:v>2.00251521361E-2</c:v>
                </c:pt>
                <c:pt idx="4">
                  <c:v>0.532699267187</c:v>
                </c:pt>
                <c:pt idx="5">
                  <c:v>1.6978412986900001E-2</c:v>
                </c:pt>
                <c:pt idx="6">
                  <c:v>1.7480734970900001E-4</c:v>
                </c:pt>
                <c:pt idx="7">
                  <c:v>0.13662320824999999</c:v>
                </c:pt>
                <c:pt idx="8">
                  <c:v>1.87675364637E-2</c:v>
                </c:pt>
                <c:pt idx="9">
                  <c:v>0.100480551262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BDFB-4196-8850-EC092246EE36}"/>
            </c:ext>
          </c:extLst>
        </c:ser>
        <c:ser>
          <c:idx val="7"/>
          <c:order val="3"/>
          <c:tx>
            <c:strRef>
              <c:f>'[PICRUSt2_result_Sum_190515 (3).xlsx]T&amp;G_C_N_P_S'!$I$301</c:f>
              <c:strCache>
                <c:ptCount val="1"/>
                <c:pt idx="0">
                  <c:v>Digged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U$302:$U$311</c:f>
                <c:numCache>
                  <c:formatCode>General</c:formatCode>
                  <c:ptCount val="10"/>
                  <c:pt idx="0">
                    <c:v>4.44440945433E-4</c:v>
                  </c:pt>
                  <c:pt idx="1">
                    <c:v>5.6689678106999999E-2</c:v>
                  </c:pt>
                  <c:pt idx="2">
                    <c:v>1.8418920312E-3</c:v>
                  </c:pt>
                  <c:pt idx="3">
                    <c:v>3.10202136016E-2</c:v>
                  </c:pt>
                  <c:pt idx="4">
                    <c:v>6.2694143475099995E-2</c:v>
                  </c:pt>
                  <c:pt idx="5">
                    <c:v>6.9178518668599996E-3</c:v>
                  </c:pt>
                  <c:pt idx="6">
                    <c:v>0</c:v>
                  </c:pt>
                  <c:pt idx="7">
                    <c:v>6.8959304030000002E-2</c:v>
                  </c:pt>
                  <c:pt idx="8">
                    <c:v>5.69580592045E-3</c:v>
                  </c:pt>
                  <c:pt idx="9">
                    <c:v>8.3428295602499994E-2</c:v>
                  </c:pt>
                </c:numCache>
              </c:numRef>
            </c:plus>
            <c:minus>
              <c:numRef>
                <c:f>'[PICRUSt2_result_Sum_190515 (3).xlsx]T&amp;G_C_N_P_S'!$U$302:$U$311</c:f>
                <c:numCache>
                  <c:formatCode>General</c:formatCode>
                  <c:ptCount val="10"/>
                  <c:pt idx="0">
                    <c:v>4.44440945433E-4</c:v>
                  </c:pt>
                  <c:pt idx="1">
                    <c:v>5.6689678106999999E-2</c:v>
                  </c:pt>
                  <c:pt idx="2">
                    <c:v>1.8418920312E-3</c:v>
                  </c:pt>
                  <c:pt idx="3">
                    <c:v>3.10202136016E-2</c:v>
                  </c:pt>
                  <c:pt idx="4">
                    <c:v>6.2694143475099995E-2</c:v>
                  </c:pt>
                  <c:pt idx="5">
                    <c:v>6.9178518668599996E-3</c:v>
                  </c:pt>
                  <c:pt idx="6">
                    <c:v>0</c:v>
                  </c:pt>
                  <c:pt idx="7">
                    <c:v>6.8959304030000002E-2</c:v>
                  </c:pt>
                  <c:pt idx="8">
                    <c:v>5.69580592045E-3</c:v>
                  </c:pt>
                  <c:pt idx="9">
                    <c:v>8.3428295602499994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302:$A$311</c:f>
              <c:strCache>
                <c:ptCount val="10"/>
                <c:pt idx="0">
                  <c:v>ammonia oxidation</c:v>
                </c:pt>
                <c:pt idx="1">
                  <c:v>nitrate dependent anaerobic methane oxidation</c:v>
                </c:pt>
                <c:pt idx="2">
                  <c:v>nitrate reduction I (denitrification)</c:v>
                </c:pt>
                <c:pt idx="3">
                  <c:v>nitrate reduction IV</c:v>
                </c:pt>
                <c:pt idx="4">
                  <c:v>nitrate reduction IX</c:v>
                </c:pt>
                <c:pt idx="5">
                  <c:v>nitrate reduction VI (assimilatory)</c:v>
                </c:pt>
                <c:pt idx="6">
                  <c:v>nitrifier denitrification</c:v>
                </c:pt>
                <c:pt idx="7">
                  <c:v>nitrogen fixation I+II</c:v>
                </c:pt>
                <c:pt idx="8">
                  <c:v>superpathway of taurine degradation</c:v>
                </c:pt>
                <c:pt idx="9">
                  <c:v>urea cycle</c:v>
                </c:pt>
              </c:strCache>
            </c:strRef>
          </c:cat>
          <c:val>
            <c:numRef>
              <c:f>'[PICRUSt2_result_Sum_190515 (3).xlsx]T&amp;G_C_N_P_S'!$I$302:$I$311</c:f>
              <c:numCache>
                <c:formatCode>General</c:formatCode>
                <c:ptCount val="10"/>
                <c:pt idx="0">
                  <c:v>5.41557843038E-4</c:v>
                </c:pt>
                <c:pt idx="1">
                  <c:v>4.9449146901499999E-2</c:v>
                </c:pt>
                <c:pt idx="2">
                  <c:v>5.5048349704199997E-3</c:v>
                </c:pt>
                <c:pt idx="3">
                  <c:v>4.81217608502E-2</c:v>
                </c:pt>
                <c:pt idx="4">
                  <c:v>0.50359557483200001</c:v>
                </c:pt>
                <c:pt idx="5">
                  <c:v>2.7460949542500002E-2</c:v>
                </c:pt>
                <c:pt idx="6">
                  <c:v>0</c:v>
                </c:pt>
                <c:pt idx="7">
                  <c:v>0.19238111261099999</c:v>
                </c:pt>
                <c:pt idx="8">
                  <c:v>2.5431921040699999E-2</c:v>
                </c:pt>
                <c:pt idx="9">
                  <c:v>0.160214281098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7-BDFB-4196-8850-EC092246EE36}"/>
            </c:ext>
          </c:extLst>
        </c:ser>
        <c:ser>
          <c:idx val="8"/>
          <c:order val="4"/>
          <c:tx>
            <c:strRef>
              <c:f>'[PICRUSt2_result_Sum_190515 (3).xlsx]T&amp;G_C_N_P_S'!$J$301</c:f>
              <c:strCache>
                <c:ptCount val="1"/>
                <c:pt idx="0">
                  <c:v>Nest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V$302:$V$311</c:f>
                <c:numCache>
                  <c:formatCode>General</c:formatCode>
                  <c:ptCount val="10"/>
                  <c:pt idx="0">
                    <c:v>7.2090567550700004E-4</c:v>
                  </c:pt>
                  <c:pt idx="1">
                    <c:v>8.2845004657300006E-2</c:v>
                  </c:pt>
                  <c:pt idx="2">
                    <c:v>4.4688029106700004E-3</c:v>
                  </c:pt>
                  <c:pt idx="3">
                    <c:v>1.6249153025100001E-2</c:v>
                  </c:pt>
                  <c:pt idx="4">
                    <c:v>7.3111702730099995E-2</c:v>
                  </c:pt>
                  <c:pt idx="5">
                    <c:v>7.7759643798000003E-2</c:v>
                  </c:pt>
                  <c:pt idx="6">
                    <c:v>1.5316907583699999E-4</c:v>
                  </c:pt>
                  <c:pt idx="7">
                    <c:v>6.93670404026E-2</c:v>
                  </c:pt>
                  <c:pt idx="8">
                    <c:v>8.5115103725100002E-3</c:v>
                  </c:pt>
                  <c:pt idx="9">
                    <c:v>5.9970838097400003E-2</c:v>
                  </c:pt>
                </c:numCache>
              </c:numRef>
            </c:plus>
            <c:minus>
              <c:numRef>
                <c:f>'[PICRUSt2_result_Sum_190515 (3).xlsx]T&amp;G_C_N_P_S'!$V$302:$V$311</c:f>
                <c:numCache>
                  <c:formatCode>General</c:formatCode>
                  <c:ptCount val="10"/>
                  <c:pt idx="0">
                    <c:v>7.2090567550700004E-4</c:v>
                  </c:pt>
                  <c:pt idx="1">
                    <c:v>8.2845004657300006E-2</c:v>
                  </c:pt>
                  <c:pt idx="2">
                    <c:v>4.4688029106700004E-3</c:v>
                  </c:pt>
                  <c:pt idx="3">
                    <c:v>1.6249153025100001E-2</c:v>
                  </c:pt>
                  <c:pt idx="4">
                    <c:v>7.3111702730099995E-2</c:v>
                  </c:pt>
                  <c:pt idx="5">
                    <c:v>7.7759643798000003E-2</c:v>
                  </c:pt>
                  <c:pt idx="6">
                    <c:v>1.5316907583699999E-4</c:v>
                  </c:pt>
                  <c:pt idx="7">
                    <c:v>6.93670404026E-2</c:v>
                  </c:pt>
                  <c:pt idx="8">
                    <c:v>8.5115103725100002E-3</c:v>
                  </c:pt>
                  <c:pt idx="9">
                    <c:v>5.9970838097400003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302:$A$311</c:f>
              <c:strCache>
                <c:ptCount val="10"/>
                <c:pt idx="0">
                  <c:v>ammonia oxidation</c:v>
                </c:pt>
                <c:pt idx="1">
                  <c:v>nitrate dependent anaerobic methane oxidation</c:v>
                </c:pt>
                <c:pt idx="2">
                  <c:v>nitrate reduction I (denitrification)</c:v>
                </c:pt>
                <c:pt idx="3">
                  <c:v>nitrate reduction IV</c:v>
                </c:pt>
                <c:pt idx="4">
                  <c:v>nitrate reduction IX</c:v>
                </c:pt>
                <c:pt idx="5">
                  <c:v>nitrate reduction VI (assimilatory)</c:v>
                </c:pt>
                <c:pt idx="6">
                  <c:v>nitrifier denitrification</c:v>
                </c:pt>
                <c:pt idx="7">
                  <c:v>nitrogen fixation I+II</c:v>
                </c:pt>
                <c:pt idx="8">
                  <c:v>superpathway of taurine degradation</c:v>
                </c:pt>
                <c:pt idx="9">
                  <c:v>urea cycle</c:v>
                </c:pt>
              </c:strCache>
            </c:strRef>
          </c:cat>
          <c:val>
            <c:numRef>
              <c:f>'[PICRUSt2_result_Sum_190515 (3).xlsx]T&amp;G_C_N_P_S'!$J$302:$J$311</c:f>
              <c:numCache>
                <c:formatCode>General</c:formatCode>
                <c:ptCount val="10"/>
                <c:pt idx="0">
                  <c:v>1.0004848235900001E-3</c:v>
                </c:pt>
                <c:pt idx="1">
                  <c:v>7.0865658288899999E-2</c:v>
                </c:pt>
                <c:pt idx="2">
                  <c:v>1.10362664516E-2</c:v>
                </c:pt>
                <c:pt idx="3">
                  <c:v>3.3022145134099998E-2</c:v>
                </c:pt>
                <c:pt idx="4">
                  <c:v>0.47776457710499998</c:v>
                </c:pt>
                <c:pt idx="5">
                  <c:v>6.9327090667599997E-2</c:v>
                </c:pt>
                <c:pt idx="6">
                  <c:v>1.08306892192E-4</c:v>
                </c:pt>
                <c:pt idx="7">
                  <c:v>0.13308342090200001</c:v>
                </c:pt>
                <c:pt idx="8">
                  <c:v>2.52972651214E-2</c:v>
                </c:pt>
                <c:pt idx="9">
                  <c:v>0.17885586778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BDFB-4196-8850-EC092246EE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1421760"/>
        <c:axId val="241420672"/>
      </c:barChart>
      <c:catAx>
        <c:axId val="2414217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1800000" spcFirstLastPara="1" vertOverflow="ellipsis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41420672"/>
        <c:crosses val="autoZero"/>
        <c:auto val="1"/>
        <c:lblAlgn val="ctr"/>
        <c:lblOffset val="100"/>
        <c:noMultiLvlLbl val="0"/>
      </c:catAx>
      <c:valAx>
        <c:axId val="241420672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414217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6350" cap="flat" cmpd="sng" algn="ctr">
      <a:noFill/>
      <a:prstDash val="solid"/>
      <a:miter lim="800000"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9388376192733635E-2"/>
          <c:y val="3.8619521616401711E-2"/>
          <c:w val="0.78325878995570042"/>
          <c:h val="0.5161394452249485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PICRUSt2_result_Sum_190515 (3).xlsx]T&amp;G_C_N_P_S'!$B$187</c:f>
              <c:strCache>
                <c:ptCount val="1"/>
                <c:pt idx="0">
                  <c:v>E.versico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O$188:$O$196</c:f>
                <c:numCache>
                  <c:formatCode>General</c:formatCode>
                  <c:ptCount val="9"/>
                  <c:pt idx="0">
                    <c:v>2.3181721416100001E-2</c:v>
                  </c:pt>
                  <c:pt idx="1">
                    <c:v>0.164675020275</c:v>
                  </c:pt>
                  <c:pt idx="2">
                    <c:v>0.13137240691099999</c:v>
                  </c:pt>
                  <c:pt idx="3">
                    <c:v>0.138985342037</c:v>
                  </c:pt>
                  <c:pt idx="4">
                    <c:v>3.7529269958600001E-3</c:v>
                  </c:pt>
                  <c:pt idx="5">
                    <c:v>5.9074926461699998E-3</c:v>
                  </c:pt>
                  <c:pt idx="6">
                    <c:v>9.47847903385E-2</c:v>
                  </c:pt>
                  <c:pt idx="7">
                    <c:v>2.4579272729900001E-2</c:v>
                  </c:pt>
                  <c:pt idx="8">
                    <c:v>0.184140981629</c:v>
                  </c:pt>
                </c:numCache>
              </c:numRef>
            </c:plus>
            <c:minus>
              <c:numRef>
                <c:f>'[PICRUSt2_result_Sum_190515 (3).xlsx]T&amp;G_C_N_P_S'!$O$188:$O$196</c:f>
                <c:numCache>
                  <c:formatCode>General</c:formatCode>
                  <c:ptCount val="9"/>
                  <c:pt idx="0">
                    <c:v>2.3181721416100001E-2</c:v>
                  </c:pt>
                  <c:pt idx="1">
                    <c:v>0.164675020275</c:v>
                  </c:pt>
                  <c:pt idx="2">
                    <c:v>0.13137240691099999</c:v>
                  </c:pt>
                  <c:pt idx="3">
                    <c:v>0.138985342037</c:v>
                  </c:pt>
                  <c:pt idx="4">
                    <c:v>3.7529269958600001E-3</c:v>
                  </c:pt>
                  <c:pt idx="5">
                    <c:v>5.9074926461699998E-3</c:v>
                  </c:pt>
                  <c:pt idx="6">
                    <c:v>9.47847903385E-2</c:v>
                  </c:pt>
                  <c:pt idx="7">
                    <c:v>2.4579272729900001E-2</c:v>
                  </c:pt>
                  <c:pt idx="8">
                    <c:v>0.184140981629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188:$A$196</c:f>
              <c:strCache>
                <c:ptCount val="9"/>
                <c:pt idx="0">
                  <c:v>assimilatory sulfate reduction II</c:v>
                </c:pt>
                <c:pt idx="1">
                  <c:v>assimilatory sulfate reduction III</c:v>
                </c:pt>
                <c:pt idx="2">
                  <c:v>sulfate reduction I (assimilatory)</c:v>
                </c:pt>
                <c:pt idx="3">
                  <c:v>sulfoacetaldehyde degradation I</c:v>
                </c:pt>
                <c:pt idx="4">
                  <c:v>sulfoacetaldehyde degradation II+III</c:v>
                </c:pt>
                <c:pt idx="5">
                  <c:v>sulfolactate degradation I</c:v>
                </c:pt>
                <c:pt idx="6">
                  <c:v>superpathway of sulfate assimilation and cysteine biosynthesis</c:v>
                </c:pt>
                <c:pt idx="7">
                  <c:v>superpathway of sulfolactate degradation</c:v>
                </c:pt>
                <c:pt idx="8">
                  <c:v>superpathway of sulfur oxidation (Acidianus ambivalens)</c:v>
                </c:pt>
              </c:strCache>
            </c:strRef>
          </c:cat>
          <c:val>
            <c:numRef>
              <c:f>'[PICRUSt2_result_Sum_190515 (3).xlsx]T&amp;G_C_N_P_S'!$B$188:$B$196</c:f>
              <c:numCache>
                <c:formatCode>General</c:formatCode>
                <c:ptCount val="9"/>
                <c:pt idx="0">
                  <c:v>9.8180141633299994E-2</c:v>
                </c:pt>
                <c:pt idx="1">
                  <c:v>0.63850916922400003</c:v>
                </c:pt>
                <c:pt idx="2">
                  <c:v>0.48585224099300001</c:v>
                </c:pt>
                <c:pt idx="3">
                  <c:v>0.43489109479600002</c:v>
                </c:pt>
                <c:pt idx="4">
                  <c:v>2.1667534113099999E-3</c:v>
                </c:pt>
                <c:pt idx="5">
                  <c:v>3.4106924695E-3</c:v>
                </c:pt>
                <c:pt idx="6">
                  <c:v>0.54163676079300005</c:v>
                </c:pt>
                <c:pt idx="7">
                  <c:v>2.1751258914E-2</c:v>
                </c:pt>
                <c:pt idx="8">
                  <c:v>0.158221797544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97A-402F-A375-C09ED7C65A51}"/>
            </c:ext>
          </c:extLst>
        </c:ser>
        <c:ser>
          <c:idx val="1"/>
          <c:order val="1"/>
          <c:tx>
            <c:strRef>
              <c:f>'[PICRUSt2_result_Sum_190515 (3).xlsx]T&amp;G_C_N_P_S'!$C$187</c:f>
              <c:strCache>
                <c:ptCount val="1"/>
                <c:pt idx="0">
                  <c:v>N.smithi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P$188:$P$196</c:f>
                <c:numCache>
                  <c:formatCode>General</c:formatCode>
                  <c:ptCount val="9"/>
                  <c:pt idx="0">
                    <c:v>9.6429367783500003E-3</c:v>
                  </c:pt>
                  <c:pt idx="1">
                    <c:v>0.16938306373000001</c:v>
                  </c:pt>
                  <c:pt idx="2">
                    <c:v>0.11040276912700001</c:v>
                  </c:pt>
                  <c:pt idx="3">
                    <c:v>4.7186414386700001E-2</c:v>
                  </c:pt>
                  <c:pt idx="4">
                    <c:v>9.6324091793599997E-4</c:v>
                  </c:pt>
                  <c:pt idx="5">
                    <c:v>0</c:v>
                  </c:pt>
                  <c:pt idx="6">
                    <c:v>7.3499131899399994E-2</c:v>
                  </c:pt>
                  <c:pt idx="7">
                    <c:v>3.1947826418999999E-3</c:v>
                  </c:pt>
                  <c:pt idx="8">
                    <c:v>0.12724524371000001</c:v>
                  </c:pt>
                </c:numCache>
              </c:numRef>
            </c:plus>
            <c:minus>
              <c:numRef>
                <c:f>'[PICRUSt2_result_Sum_190515 (3).xlsx]T&amp;G_C_N_P_S'!$P$188:$P$196</c:f>
                <c:numCache>
                  <c:formatCode>General</c:formatCode>
                  <c:ptCount val="9"/>
                  <c:pt idx="0">
                    <c:v>9.6429367783500003E-3</c:v>
                  </c:pt>
                  <c:pt idx="1">
                    <c:v>0.16938306373000001</c:v>
                  </c:pt>
                  <c:pt idx="2">
                    <c:v>0.11040276912700001</c:v>
                  </c:pt>
                  <c:pt idx="3">
                    <c:v>4.7186414386700001E-2</c:v>
                  </c:pt>
                  <c:pt idx="4">
                    <c:v>9.6324091793599997E-4</c:v>
                  </c:pt>
                  <c:pt idx="5">
                    <c:v>0</c:v>
                  </c:pt>
                  <c:pt idx="6">
                    <c:v>7.3499131899399994E-2</c:v>
                  </c:pt>
                  <c:pt idx="7">
                    <c:v>3.1947826418999999E-3</c:v>
                  </c:pt>
                  <c:pt idx="8">
                    <c:v>0.12724524371000001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188:$A$196</c:f>
              <c:strCache>
                <c:ptCount val="9"/>
                <c:pt idx="0">
                  <c:v>assimilatory sulfate reduction II</c:v>
                </c:pt>
                <c:pt idx="1">
                  <c:v>assimilatory sulfate reduction III</c:v>
                </c:pt>
                <c:pt idx="2">
                  <c:v>sulfate reduction I (assimilatory)</c:v>
                </c:pt>
                <c:pt idx="3">
                  <c:v>sulfoacetaldehyde degradation I</c:v>
                </c:pt>
                <c:pt idx="4">
                  <c:v>sulfoacetaldehyde degradation II+III</c:v>
                </c:pt>
                <c:pt idx="5">
                  <c:v>sulfolactate degradation I</c:v>
                </c:pt>
                <c:pt idx="6">
                  <c:v>superpathway of sulfate assimilation and cysteine biosynthesis</c:v>
                </c:pt>
                <c:pt idx="7">
                  <c:v>superpathway of sulfolactate degradation</c:v>
                </c:pt>
                <c:pt idx="8">
                  <c:v>superpathway of sulfur oxidation (Acidianus ambivalens)</c:v>
                </c:pt>
              </c:strCache>
            </c:strRef>
          </c:cat>
          <c:val>
            <c:numRef>
              <c:f>'[PICRUSt2_result_Sum_190515 (3).xlsx]T&amp;G_C_N_P_S'!$C$188:$C$196</c:f>
              <c:numCache>
                <c:formatCode>General</c:formatCode>
                <c:ptCount val="9"/>
                <c:pt idx="0">
                  <c:v>3.6672680247299999E-2</c:v>
                </c:pt>
                <c:pt idx="1">
                  <c:v>0.68181818509000003</c:v>
                </c:pt>
                <c:pt idx="2">
                  <c:v>0.47364950735</c:v>
                </c:pt>
                <c:pt idx="3">
                  <c:v>0.56824042597900004</c:v>
                </c:pt>
                <c:pt idx="4">
                  <c:v>1.3214154956000001E-3</c:v>
                </c:pt>
                <c:pt idx="5">
                  <c:v>0</c:v>
                </c:pt>
                <c:pt idx="6">
                  <c:v>0.55240203792200004</c:v>
                </c:pt>
                <c:pt idx="7">
                  <c:v>9.4651862820699997E-3</c:v>
                </c:pt>
                <c:pt idx="8">
                  <c:v>0.12937774226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97A-402F-A375-C09ED7C65A51}"/>
            </c:ext>
          </c:extLst>
        </c:ser>
        <c:ser>
          <c:idx val="2"/>
          <c:order val="2"/>
          <c:tx>
            <c:strRef>
              <c:f>'[PICRUSt2_result_Sum_190515 (3).xlsx]T&amp;G_C_N_P_S'!$D$187</c:f>
              <c:strCache>
                <c:ptCount val="1"/>
                <c:pt idx="0">
                  <c:v>P.indiaru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Q$188:$Q$196</c:f>
                <c:numCache>
                  <c:formatCode>General</c:formatCode>
                  <c:ptCount val="9"/>
                  <c:pt idx="0">
                    <c:v>6.5098388091199999E-2</c:v>
                  </c:pt>
                  <c:pt idx="1">
                    <c:v>4.9881529531299998E-2</c:v>
                  </c:pt>
                  <c:pt idx="2">
                    <c:v>3.8846943000000002E-2</c:v>
                  </c:pt>
                  <c:pt idx="3">
                    <c:v>7.1357329291900001E-2</c:v>
                  </c:pt>
                  <c:pt idx="4">
                    <c:v>3.1082276879499998E-3</c:v>
                  </c:pt>
                  <c:pt idx="5">
                    <c:v>3.8889668338899998E-3</c:v>
                  </c:pt>
                  <c:pt idx="6">
                    <c:v>4.1798874575900001E-2</c:v>
                  </c:pt>
                  <c:pt idx="7">
                    <c:v>7.5094813331E-3</c:v>
                  </c:pt>
                  <c:pt idx="8">
                    <c:v>5.2830152237699997E-2</c:v>
                  </c:pt>
                </c:numCache>
              </c:numRef>
            </c:plus>
            <c:minus>
              <c:numRef>
                <c:f>'[PICRUSt2_result_Sum_190515 (3).xlsx]T&amp;G_C_N_P_S'!$Q$188:$Q$196</c:f>
                <c:numCache>
                  <c:formatCode>General</c:formatCode>
                  <c:ptCount val="9"/>
                  <c:pt idx="0">
                    <c:v>6.5098388091199999E-2</c:v>
                  </c:pt>
                  <c:pt idx="1">
                    <c:v>4.9881529531299998E-2</c:v>
                  </c:pt>
                  <c:pt idx="2">
                    <c:v>3.8846943000000002E-2</c:v>
                  </c:pt>
                  <c:pt idx="3">
                    <c:v>7.1357329291900001E-2</c:v>
                  </c:pt>
                  <c:pt idx="4">
                    <c:v>3.1082276879499998E-3</c:v>
                  </c:pt>
                  <c:pt idx="5">
                    <c:v>3.8889668338899998E-3</c:v>
                  </c:pt>
                  <c:pt idx="6">
                    <c:v>4.1798874575900001E-2</c:v>
                  </c:pt>
                  <c:pt idx="7">
                    <c:v>7.5094813331E-3</c:v>
                  </c:pt>
                  <c:pt idx="8">
                    <c:v>5.2830152237699997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188:$A$196</c:f>
              <c:strCache>
                <c:ptCount val="9"/>
                <c:pt idx="0">
                  <c:v>assimilatory sulfate reduction II</c:v>
                </c:pt>
                <c:pt idx="1">
                  <c:v>assimilatory sulfate reduction III</c:v>
                </c:pt>
                <c:pt idx="2">
                  <c:v>sulfate reduction I (assimilatory)</c:v>
                </c:pt>
                <c:pt idx="3">
                  <c:v>sulfoacetaldehyde degradation I</c:v>
                </c:pt>
                <c:pt idx="4">
                  <c:v>sulfoacetaldehyde degradation II+III</c:v>
                </c:pt>
                <c:pt idx="5">
                  <c:v>sulfolactate degradation I</c:v>
                </c:pt>
                <c:pt idx="6">
                  <c:v>superpathway of sulfate assimilation and cysteine biosynthesis</c:v>
                </c:pt>
                <c:pt idx="7">
                  <c:v>superpathway of sulfolactate degradation</c:v>
                </c:pt>
                <c:pt idx="8">
                  <c:v>superpathway of sulfur oxidation (Acidianus ambivalens)</c:v>
                </c:pt>
              </c:strCache>
            </c:strRef>
          </c:cat>
          <c:val>
            <c:numRef>
              <c:f>'[PICRUSt2_result_Sum_190515 (3).xlsx]T&amp;G_C_N_P_S'!$D$188:$D$196</c:f>
              <c:numCache>
                <c:formatCode>General</c:formatCode>
                <c:ptCount val="9"/>
                <c:pt idx="0">
                  <c:v>0.194767933389</c:v>
                </c:pt>
                <c:pt idx="1">
                  <c:v>0.65032896574700005</c:v>
                </c:pt>
                <c:pt idx="2">
                  <c:v>0.56072534879400004</c:v>
                </c:pt>
                <c:pt idx="3">
                  <c:v>0.34425951120300002</c:v>
                </c:pt>
                <c:pt idx="4">
                  <c:v>2.0692882131199998E-3</c:v>
                </c:pt>
                <c:pt idx="5">
                  <c:v>3.5015004036E-3</c:v>
                </c:pt>
                <c:pt idx="6">
                  <c:v>0.61380638223600004</c:v>
                </c:pt>
                <c:pt idx="7">
                  <c:v>1.30098910738E-2</c:v>
                </c:pt>
                <c:pt idx="8">
                  <c:v>0.1043764287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297A-402F-A375-C09ED7C65A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1292976"/>
        <c:axId val="371286992"/>
      </c:barChart>
      <c:catAx>
        <c:axId val="3712929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1800000" spcFirstLastPara="1" vertOverflow="ellipsis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71286992"/>
        <c:crosses val="autoZero"/>
        <c:auto val="1"/>
        <c:lblAlgn val="ctr"/>
        <c:lblOffset val="100"/>
        <c:noMultiLvlLbl val="0"/>
      </c:catAx>
      <c:valAx>
        <c:axId val="371286992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712929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 w="6350" cap="flat" cmpd="sng" algn="ctr">
      <a:noFill/>
      <a:prstDash val="solid"/>
      <a:miter lim="800000"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8589966152744762E-2"/>
          <c:y val="5.161531223691377E-2"/>
          <c:w val="0.80158942696523883"/>
          <c:h val="0.45335116129351755"/>
        </c:manualLayout>
      </c:layout>
      <c:barChart>
        <c:barDir val="col"/>
        <c:grouping val="clustered"/>
        <c:varyColors val="0"/>
        <c:ser>
          <c:idx val="4"/>
          <c:order val="0"/>
          <c:tx>
            <c:strRef>
              <c:f>'[PICRUSt2_result_Sum_190515 (3).xlsx]T&amp;G_C_N_P_S'!$F$187</c:f>
              <c:strCache>
                <c:ptCount val="1"/>
                <c:pt idx="0">
                  <c:v>Upper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R$188:$R$196</c:f>
                <c:numCache>
                  <c:formatCode>General</c:formatCode>
                  <c:ptCount val="9"/>
                  <c:pt idx="0">
                    <c:v>4.83085146861E-2</c:v>
                  </c:pt>
                  <c:pt idx="1">
                    <c:v>3.9090186525999999E-2</c:v>
                  </c:pt>
                  <c:pt idx="2">
                    <c:v>5.1606903245800001E-2</c:v>
                  </c:pt>
                  <c:pt idx="3">
                    <c:v>3.0408857461699999E-2</c:v>
                  </c:pt>
                  <c:pt idx="4">
                    <c:v>3.9403315465999999E-4</c:v>
                  </c:pt>
                  <c:pt idx="5">
                    <c:v>7.9950328238800005E-4</c:v>
                  </c:pt>
                  <c:pt idx="6">
                    <c:v>2.1095958885200002E-2</c:v>
                  </c:pt>
                  <c:pt idx="7">
                    <c:v>1.1063136822600001E-3</c:v>
                  </c:pt>
                  <c:pt idx="8">
                    <c:v>2.7202071080300001E-2</c:v>
                  </c:pt>
                </c:numCache>
              </c:numRef>
            </c:plus>
            <c:minus>
              <c:numRef>
                <c:f>'[PICRUSt2_result_Sum_190515 (3).xlsx]T&amp;G_C_N_P_S'!$R$188:$R$196</c:f>
                <c:numCache>
                  <c:formatCode>General</c:formatCode>
                  <c:ptCount val="9"/>
                  <c:pt idx="0">
                    <c:v>4.83085146861E-2</c:v>
                  </c:pt>
                  <c:pt idx="1">
                    <c:v>3.9090186525999999E-2</c:v>
                  </c:pt>
                  <c:pt idx="2">
                    <c:v>5.1606903245800001E-2</c:v>
                  </c:pt>
                  <c:pt idx="3">
                    <c:v>3.0408857461699999E-2</c:v>
                  </c:pt>
                  <c:pt idx="4">
                    <c:v>3.9403315465999999E-4</c:v>
                  </c:pt>
                  <c:pt idx="5">
                    <c:v>7.9950328238800005E-4</c:v>
                  </c:pt>
                  <c:pt idx="6">
                    <c:v>2.1095958885200002E-2</c:v>
                  </c:pt>
                  <c:pt idx="7">
                    <c:v>1.1063136822600001E-3</c:v>
                  </c:pt>
                  <c:pt idx="8">
                    <c:v>2.7202071080300001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188:$A$196</c:f>
              <c:strCache>
                <c:ptCount val="9"/>
                <c:pt idx="0">
                  <c:v>assimilatory sulfate reduction II</c:v>
                </c:pt>
                <c:pt idx="1">
                  <c:v>assimilatory sulfate reduction III</c:v>
                </c:pt>
                <c:pt idx="2">
                  <c:v>sulfate reduction I (assimilatory)</c:v>
                </c:pt>
                <c:pt idx="3">
                  <c:v>sulfoacetaldehyde degradation I</c:v>
                </c:pt>
                <c:pt idx="4">
                  <c:v>sulfoacetaldehyde degradation II+III</c:v>
                </c:pt>
                <c:pt idx="5">
                  <c:v>sulfolactate degradation I</c:v>
                </c:pt>
                <c:pt idx="6">
                  <c:v>superpathway of sulfate assimilation and cysteine biosynthesis</c:v>
                </c:pt>
                <c:pt idx="7">
                  <c:v>superpathway of sulfolactate degradation</c:v>
                </c:pt>
                <c:pt idx="8">
                  <c:v>superpathway of sulfur oxidation (Acidianus ambivalens)</c:v>
                </c:pt>
              </c:strCache>
            </c:strRef>
          </c:cat>
          <c:val>
            <c:numRef>
              <c:f>'[PICRUSt2_result_Sum_190515 (3).xlsx]T&amp;G_C_N_P_S'!$F$188:$F$196</c:f>
              <c:numCache>
                <c:formatCode>General</c:formatCode>
                <c:ptCount val="9"/>
                <c:pt idx="0">
                  <c:v>0.13325542665099999</c:v>
                </c:pt>
                <c:pt idx="1">
                  <c:v>0.58225819457299999</c:v>
                </c:pt>
                <c:pt idx="2">
                  <c:v>0.50199822985800002</c:v>
                </c:pt>
                <c:pt idx="3">
                  <c:v>0.17327319246</c:v>
                </c:pt>
                <c:pt idx="4">
                  <c:v>4.27037142775E-4</c:v>
                </c:pt>
                <c:pt idx="5">
                  <c:v>1.2240556373999999E-3</c:v>
                </c:pt>
                <c:pt idx="6">
                  <c:v>0.55600539374500002</c:v>
                </c:pt>
                <c:pt idx="7">
                  <c:v>1.8559282385099999E-3</c:v>
                </c:pt>
                <c:pt idx="8">
                  <c:v>0.132566682905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AC88-47E6-9490-69F37CCABD8F}"/>
            </c:ext>
          </c:extLst>
        </c:ser>
        <c:ser>
          <c:idx val="5"/>
          <c:order val="1"/>
          <c:tx>
            <c:strRef>
              <c:f>'[PICRUSt2_result_Sum_190515 (3).xlsx]T&amp;G_C_N_P_S'!$G$187</c:f>
              <c:strCache>
                <c:ptCount val="1"/>
                <c:pt idx="0">
                  <c:v>Middle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S$188:$S$196</c:f>
                <c:numCache>
                  <c:formatCode>General</c:formatCode>
                  <c:ptCount val="9"/>
                  <c:pt idx="0">
                    <c:v>1.7892839779000001E-2</c:v>
                  </c:pt>
                  <c:pt idx="1">
                    <c:v>0.16501839680300001</c:v>
                  </c:pt>
                  <c:pt idx="2">
                    <c:v>7.8461628497100006E-2</c:v>
                  </c:pt>
                  <c:pt idx="3">
                    <c:v>5.1499106862899997E-2</c:v>
                  </c:pt>
                  <c:pt idx="4">
                    <c:v>7.3714674102799997E-4</c:v>
                  </c:pt>
                  <c:pt idx="5">
                    <c:v>7.9275901760899996E-4</c:v>
                  </c:pt>
                  <c:pt idx="6">
                    <c:v>5.3629155388599997E-2</c:v>
                  </c:pt>
                  <c:pt idx="7">
                    <c:v>3.3301539139200002E-3</c:v>
                  </c:pt>
                  <c:pt idx="8">
                    <c:v>4.86435105748E-2</c:v>
                  </c:pt>
                </c:numCache>
              </c:numRef>
            </c:plus>
            <c:minus>
              <c:numRef>
                <c:f>'[PICRUSt2_result_Sum_190515 (3).xlsx]T&amp;G_C_N_P_S'!$S$188:$S$196</c:f>
                <c:numCache>
                  <c:formatCode>General</c:formatCode>
                  <c:ptCount val="9"/>
                  <c:pt idx="0">
                    <c:v>1.7892839779000001E-2</c:v>
                  </c:pt>
                  <c:pt idx="1">
                    <c:v>0.16501839680300001</c:v>
                  </c:pt>
                  <c:pt idx="2">
                    <c:v>7.8461628497100006E-2</c:v>
                  </c:pt>
                  <c:pt idx="3">
                    <c:v>5.1499106862899997E-2</c:v>
                  </c:pt>
                  <c:pt idx="4">
                    <c:v>7.3714674102799997E-4</c:v>
                  </c:pt>
                  <c:pt idx="5">
                    <c:v>7.9275901760899996E-4</c:v>
                  </c:pt>
                  <c:pt idx="6">
                    <c:v>5.3629155388599997E-2</c:v>
                  </c:pt>
                  <c:pt idx="7">
                    <c:v>3.3301539139200002E-3</c:v>
                  </c:pt>
                  <c:pt idx="8">
                    <c:v>4.86435105748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188:$A$196</c:f>
              <c:strCache>
                <c:ptCount val="9"/>
                <c:pt idx="0">
                  <c:v>assimilatory sulfate reduction II</c:v>
                </c:pt>
                <c:pt idx="1">
                  <c:v>assimilatory sulfate reduction III</c:v>
                </c:pt>
                <c:pt idx="2">
                  <c:v>sulfate reduction I (assimilatory)</c:v>
                </c:pt>
                <c:pt idx="3">
                  <c:v>sulfoacetaldehyde degradation I</c:v>
                </c:pt>
                <c:pt idx="4">
                  <c:v>sulfoacetaldehyde degradation II+III</c:v>
                </c:pt>
                <c:pt idx="5">
                  <c:v>sulfolactate degradation I</c:v>
                </c:pt>
                <c:pt idx="6">
                  <c:v>superpathway of sulfate assimilation and cysteine biosynthesis</c:v>
                </c:pt>
                <c:pt idx="7">
                  <c:v>superpathway of sulfolactate degradation</c:v>
                </c:pt>
                <c:pt idx="8">
                  <c:v>superpathway of sulfur oxidation (Acidianus ambivalens)</c:v>
                </c:pt>
              </c:strCache>
            </c:strRef>
          </c:cat>
          <c:val>
            <c:numRef>
              <c:f>'[PICRUSt2_result_Sum_190515 (3).xlsx]T&amp;G_C_N_P_S'!$G$188:$G$196</c:f>
              <c:numCache>
                <c:formatCode>General</c:formatCode>
                <c:ptCount val="9"/>
                <c:pt idx="0">
                  <c:v>5.6330179773500001E-2</c:v>
                </c:pt>
                <c:pt idx="1">
                  <c:v>0.48054721440100001</c:v>
                </c:pt>
                <c:pt idx="2">
                  <c:v>0.41645558938100002</c:v>
                </c:pt>
                <c:pt idx="3">
                  <c:v>0.246851059506</c:v>
                </c:pt>
                <c:pt idx="4">
                  <c:v>1.0745014461600001E-3</c:v>
                </c:pt>
                <c:pt idx="5">
                  <c:v>1.3149365985999999E-3</c:v>
                </c:pt>
                <c:pt idx="6">
                  <c:v>0.51480909103000005</c:v>
                </c:pt>
                <c:pt idx="7">
                  <c:v>4.4820847109900003E-3</c:v>
                </c:pt>
                <c:pt idx="8">
                  <c:v>0.2393777017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AC88-47E6-9490-69F37CCABD8F}"/>
            </c:ext>
          </c:extLst>
        </c:ser>
        <c:ser>
          <c:idx val="6"/>
          <c:order val="2"/>
          <c:tx>
            <c:strRef>
              <c:f>'[PICRUSt2_result_Sum_190515 (3).xlsx]T&amp;G_C_N_P_S'!$H$187</c:f>
              <c:strCache>
                <c:ptCount val="1"/>
                <c:pt idx="0">
                  <c:v>Lower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T$188:$T$196</c:f>
                <c:numCache>
                  <c:formatCode>General</c:formatCode>
                  <c:ptCount val="9"/>
                  <c:pt idx="0">
                    <c:v>1.2285604151200001E-2</c:v>
                  </c:pt>
                  <c:pt idx="1">
                    <c:v>9.0896063979400005E-2</c:v>
                  </c:pt>
                  <c:pt idx="2">
                    <c:v>4.9920832637500002E-2</c:v>
                  </c:pt>
                  <c:pt idx="3">
                    <c:v>5.3951963375299998E-2</c:v>
                  </c:pt>
                  <c:pt idx="4">
                    <c:v>2.8702395499700001E-4</c:v>
                  </c:pt>
                  <c:pt idx="5">
                    <c:v>1.2898892467199999E-3</c:v>
                  </c:pt>
                  <c:pt idx="6">
                    <c:v>3.2852579297499997E-2</c:v>
                  </c:pt>
                  <c:pt idx="7">
                    <c:v>3.9000555672400001E-3</c:v>
                  </c:pt>
                  <c:pt idx="8">
                    <c:v>3.7682264949899999E-2</c:v>
                  </c:pt>
                </c:numCache>
              </c:numRef>
            </c:plus>
            <c:minus>
              <c:numRef>
                <c:f>'[PICRUSt2_result_Sum_190515 (3).xlsx]T&amp;G_C_N_P_S'!$T$188:$T$196</c:f>
                <c:numCache>
                  <c:formatCode>General</c:formatCode>
                  <c:ptCount val="9"/>
                  <c:pt idx="0">
                    <c:v>1.2285604151200001E-2</c:v>
                  </c:pt>
                  <c:pt idx="1">
                    <c:v>9.0896063979400005E-2</c:v>
                  </c:pt>
                  <c:pt idx="2">
                    <c:v>4.9920832637500002E-2</c:v>
                  </c:pt>
                  <c:pt idx="3">
                    <c:v>5.3951963375299998E-2</c:v>
                  </c:pt>
                  <c:pt idx="4">
                    <c:v>2.8702395499700001E-4</c:v>
                  </c:pt>
                  <c:pt idx="5">
                    <c:v>1.2898892467199999E-3</c:v>
                  </c:pt>
                  <c:pt idx="6">
                    <c:v>3.2852579297499997E-2</c:v>
                  </c:pt>
                  <c:pt idx="7">
                    <c:v>3.9000555672400001E-3</c:v>
                  </c:pt>
                  <c:pt idx="8">
                    <c:v>3.7682264949899999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188:$A$196</c:f>
              <c:strCache>
                <c:ptCount val="9"/>
                <c:pt idx="0">
                  <c:v>assimilatory sulfate reduction II</c:v>
                </c:pt>
                <c:pt idx="1">
                  <c:v>assimilatory sulfate reduction III</c:v>
                </c:pt>
                <c:pt idx="2">
                  <c:v>sulfate reduction I (assimilatory)</c:v>
                </c:pt>
                <c:pt idx="3">
                  <c:v>sulfoacetaldehyde degradation I</c:v>
                </c:pt>
                <c:pt idx="4">
                  <c:v>sulfoacetaldehyde degradation II+III</c:v>
                </c:pt>
                <c:pt idx="5">
                  <c:v>sulfolactate degradation I</c:v>
                </c:pt>
                <c:pt idx="6">
                  <c:v>superpathway of sulfate assimilation and cysteine biosynthesis</c:v>
                </c:pt>
                <c:pt idx="7">
                  <c:v>superpathway of sulfolactate degradation</c:v>
                </c:pt>
                <c:pt idx="8">
                  <c:v>superpathway of sulfur oxidation (Acidianus ambivalens)</c:v>
                </c:pt>
              </c:strCache>
            </c:strRef>
          </c:cat>
          <c:val>
            <c:numRef>
              <c:f>'[PICRUSt2_result_Sum_190515 (3).xlsx]T&amp;G_C_N_P_S'!$H$188:$H$196</c:f>
              <c:numCache>
                <c:formatCode>General</c:formatCode>
                <c:ptCount val="9"/>
                <c:pt idx="0">
                  <c:v>7.5175538832700006E-2</c:v>
                </c:pt>
                <c:pt idx="1">
                  <c:v>0.52392981642799996</c:v>
                </c:pt>
                <c:pt idx="2">
                  <c:v>0.45066147268599999</c:v>
                </c:pt>
                <c:pt idx="3">
                  <c:v>0.22179311561500001</c:v>
                </c:pt>
                <c:pt idx="4">
                  <c:v>3.6213634266499999E-4</c:v>
                </c:pt>
                <c:pt idx="5">
                  <c:v>1.2688112491999999E-3</c:v>
                </c:pt>
                <c:pt idx="6">
                  <c:v>0.53455464185299995</c:v>
                </c:pt>
                <c:pt idx="7">
                  <c:v>4.6312161066900002E-3</c:v>
                </c:pt>
                <c:pt idx="8">
                  <c:v>0.168400801650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AC88-47E6-9490-69F37CCABD8F}"/>
            </c:ext>
          </c:extLst>
        </c:ser>
        <c:ser>
          <c:idx val="7"/>
          <c:order val="3"/>
          <c:tx>
            <c:strRef>
              <c:f>'[PICRUSt2_result_Sum_190515 (3).xlsx]T&amp;G_C_N_P_S'!$I$187</c:f>
              <c:strCache>
                <c:ptCount val="1"/>
                <c:pt idx="0">
                  <c:v>Digged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U$188:$U$196</c:f>
                <c:numCache>
                  <c:formatCode>General</c:formatCode>
                  <c:ptCount val="9"/>
                  <c:pt idx="0">
                    <c:v>1.79505169784E-2</c:v>
                  </c:pt>
                  <c:pt idx="1">
                    <c:v>0.16670296156299999</c:v>
                  </c:pt>
                  <c:pt idx="2">
                    <c:v>9.4893430622099997E-2</c:v>
                  </c:pt>
                  <c:pt idx="3">
                    <c:v>4.1217610377000002E-2</c:v>
                  </c:pt>
                  <c:pt idx="4">
                    <c:v>2.5861178896399999E-3</c:v>
                  </c:pt>
                  <c:pt idx="5">
                    <c:v>2.82352187891E-4</c:v>
                  </c:pt>
                  <c:pt idx="6">
                    <c:v>6.7542646884200003E-2</c:v>
                  </c:pt>
                  <c:pt idx="7">
                    <c:v>3.3269294956900001E-3</c:v>
                  </c:pt>
                  <c:pt idx="8">
                    <c:v>6.9375928886200006E-2</c:v>
                  </c:pt>
                </c:numCache>
              </c:numRef>
            </c:plus>
            <c:minus>
              <c:numRef>
                <c:f>'[PICRUSt2_result_Sum_190515 (3).xlsx]T&amp;G_C_N_P_S'!$U$188:$U$196</c:f>
                <c:numCache>
                  <c:formatCode>General</c:formatCode>
                  <c:ptCount val="9"/>
                  <c:pt idx="0">
                    <c:v>1.79505169784E-2</c:v>
                  </c:pt>
                  <c:pt idx="1">
                    <c:v>0.16670296156299999</c:v>
                  </c:pt>
                  <c:pt idx="2">
                    <c:v>9.4893430622099997E-2</c:v>
                  </c:pt>
                  <c:pt idx="3">
                    <c:v>4.1217610377000002E-2</c:v>
                  </c:pt>
                  <c:pt idx="4">
                    <c:v>2.5861178896399999E-3</c:v>
                  </c:pt>
                  <c:pt idx="5">
                    <c:v>2.82352187891E-4</c:v>
                  </c:pt>
                  <c:pt idx="6">
                    <c:v>6.7542646884200003E-2</c:v>
                  </c:pt>
                  <c:pt idx="7">
                    <c:v>3.3269294956900001E-3</c:v>
                  </c:pt>
                  <c:pt idx="8">
                    <c:v>6.9375928886200006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188:$A$196</c:f>
              <c:strCache>
                <c:ptCount val="9"/>
                <c:pt idx="0">
                  <c:v>assimilatory sulfate reduction II</c:v>
                </c:pt>
                <c:pt idx="1">
                  <c:v>assimilatory sulfate reduction III</c:v>
                </c:pt>
                <c:pt idx="2">
                  <c:v>sulfate reduction I (assimilatory)</c:v>
                </c:pt>
                <c:pt idx="3">
                  <c:v>sulfoacetaldehyde degradation I</c:v>
                </c:pt>
                <c:pt idx="4">
                  <c:v>sulfoacetaldehyde degradation II+III</c:v>
                </c:pt>
                <c:pt idx="5">
                  <c:v>sulfolactate degradation I</c:v>
                </c:pt>
                <c:pt idx="6">
                  <c:v>superpathway of sulfate assimilation and cysteine biosynthesis</c:v>
                </c:pt>
                <c:pt idx="7">
                  <c:v>superpathway of sulfolactate degradation</c:v>
                </c:pt>
                <c:pt idx="8">
                  <c:v>superpathway of sulfur oxidation (Acidianus ambivalens)</c:v>
                </c:pt>
              </c:strCache>
            </c:strRef>
          </c:cat>
          <c:val>
            <c:numRef>
              <c:f>'[PICRUSt2_result_Sum_190515 (3).xlsx]T&amp;G_C_N_P_S'!$I$188:$I$196</c:f>
              <c:numCache>
                <c:formatCode>General</c:formatCode>
                <c:ptCount val="9"/>
                <c:pt idx="0">
                  <c:v>7.32840965825E-2</c:v>
                </c:pt>
                <c:pt idx="1">
                  <c:v>0.46904295489600001</c:v>
                </c:pt>
                <c:pt idx="2">
                  <c:v>0.38608440076599998</c:v>
                </c:pt>
                <c:pt idx="3">
                  <c:v>0.19171901723400001</c:v>
                </c:pt>
                <c:pt idx="4">
                  <c:v>2.96834699431E-3</c:v>
                </c:pt>
                <c:pt idx="5">
                  <c:v>3.8753970498199997E-4</c:v>
                </c:pt>
                <c:pt idx="6">
                  <c:v>0.47736407759600002</c:v>
                </c:pt>
                <c:pt idx="7">
                  <c:v>5.7331661470500003E-3</c:v>
                </c:pt>
                <c:pt idx="8">
                  <c:v>0.221672476637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7-AC88-47E6-9490-69F37CCABD8F}"/>
            </c:ext>
          </c:extLst>
        </c:ser>
        <c:ser>
          <c:idx val="8"/>
          <c:order val="4"/>
          <c:tx>
            <c:strRef>
              <c:f>'[PICRUSt2_result_Sum_190515 (3).xlsx]T&amp;G_C_N_P_S'!$J$187</c:f>
              <c:strCache>
                <c:ptCount val="1"/>
                <c:pt idx="0">
                  <c:v>Nest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ICRUSt2_result_Sum_190515 (3).xlsx]T&amp;G_C_N_P_S'!$V$188:$V$196</c:f>
                <c:numCache>
                  <c:formatCode>General</c:formatCode>
                  <c:ptCount val="9"/>
                  <c:pt idx="0">
                    <c:v>8.7770731669099995E-3</c:v>
                  </c:pt>
                  <c:pt idx="1">
                    <c:v>0.166493318492</c:v>
                  </c:pt>
                  <c:pt idx="2">
                    <c:v>9.92769922188E-2</c:v>
                  </c:pt>
                  <c:pt idx="3">
                    <c:v>3.9062601713499998E-2</c:v>
                  </c:pt>
                  <c:pt idx="4">
                    <c:v>6.5839857977999998E-4</c:v>
                  </c:pt>
                  <c:pt idx="5">
                    <c:v>1.1335034638299999E-3</c:v>
                  </c:pt>
                  <c:pt idx="6">
                    <c:v>5.6133291181699997E-2</c:v>
                  </c:pt>
                  <c:pt idx="7">
                    <c:v>1.50433812152E-3</c:v>
                  </c:pt>
                  <c:pt idx="8">
                    <c:v>6.1685383854799998E-2</c:v>
                  </c:pt>
                </c:numCache>
              </c:numRef>
            </c:plus>
            <c:minus>
              <c:numRef>
                <c:f>'[PICRUSt2_result_Sum_190515 (3).xlsx]T&amp;G_C_N_P_S'!$V$188:$V$196</c:f>
                <c:numCache>
                  <c:formatCode>General</c:formatCode>
                  <c:ptCount val="9"/>
                  <c:pt idx="0">
                    <c:v>8.7770731669099995E-3</c:v>
                  </c:pt>
                  <c:pt idx="1">
                    <c:v>0.166493318492</c:v>
                  </c:pt>
                  <c:pt idx="2">
                    <c:v>9.92769922188E-2</c:v>
                  </c:pt>
                  <c:pt idx="3">
                    <c:v>3.9062601713499998E-2</c:v>
                  </c:pt>
                  <c:pt idx="4">
                    <c:v>6.5839857977999998E-4</c:v>
                  </c:pt>
                  <c:pt idx="5">
                    <c:v>1.1335034638299999E-3</c:v>
                  </c:pt>
                  <c:pt idx="6">
                    <c:v>5.6133291181699997E-2</c:v>
                  </c:pt>
                  <c:pt idx="7">
                    <c:v>1.50433812152E-3</c:v>
                  </c:pt>
                  <c:pt idx="8">
                    <c:v>6.1685383854799998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[PICRUSt2_result_Sum_190515 (3).xlsx]T&amp;G_C_N_P_S'!$A$188:$A$196</c:f>
              <c:strCache>
                <c:ptCount val="9"/>
                <c:pt idx="0">
                  <c:v>assimilatory sulfate reduction II</c:v>
                </c:pt>
                <c:pt idx="1">
                  <c:v>assimilatory sulfate reduction III</c:v>
                </c:pt>
                <c:pt idx="2">
                  <c:v>sulfate reduction I (assimilatory)</c:v>
                </c:pt>
                <c:pt idx="3">
                  <c:v>sulfoacetaldehyde degradation I</c:v>
                </c:pt>
                <c:pt idx="4">
                  <c:v>sulfoacetaldehyde degradation II+III</c:v>
                </c:pt>
                <c:pt idx="5">
                  <c:v>sulfolactate degradation I</c:v>
                </c:pt>
                <c:pt idx="6">
                  <c:v>superpathway of sulfate assimilation and cysteine biosynthesis</c:v>
                </c:pt>
                <c:pt idx="7">
                  <c:v>superpathway of sulfolactate degradation</c:v>
                </c:pt>
                <c:pt idx="8">
                  <c:v>superpathway of sulfur oxidation (Acidianus ambivalens)</c:v>
                </c:pt>
              </c:strCache>
            </c:strRef>
          </c:cat>
          <c:val>
            <c:numRef>
              <c:f>'[PICRUSt2_result_Sum_190515 (3).xlsx]T&amp;G_C_N_P_S'!$J$188:$J$196</c:f>
              <c:numCache>
                <c:formatCode>General</c:formatCode>
                <c:ptCount val="9"/>
                <c:pt idx="0">
                  <c:v>8.9140711942100007E-2</c:v>
                </c:pt>
                <c:pt idx="1">
                  <c:v>0.58471872012600001</c:v>
                </c:pt>
                <c:pt idx="2">
                  <c:v>0.47646765696499999</c:v>
                </c:pt>
                <c:pt idx="3">
                  <c:v>0.17822520472200001</c:v>
                </c:pt>
                <c:pt idx="4">
                  <c:v>6.9308757486099995E-4</c:v>
                </c:pt>
                <c:pt idx="5">
                  <c:v>1.5813185687299999E-3</c:v>
                </c:pt>
                <c:pt idx="6">
                  <c:v>0.53823504222999996</c:v>
                </c:pt>
                <c:pt idx="7">
                  <c:v>1.5695141535599999E-3</c:v>
                </c:pt>
                <c:pt idx="8">
                  <c:v>0.15206497260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AC88-47E6-9490-69F37CCABD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1294064"/>
        <c:axId val="371287536"/>
      </c:barChart>
      <c:catAx>
        <c:axId val="37129406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1800000" spcFirstLastPara="1" vertOverflow="ellipsis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71287536"/>
        <c:crosses val="autoZero"/>
        <c:auto val="1"/>
        <c:lblAlgn val="ctr"/>
        <c:lblOffset val="100"/>
        <c:noMultiLvlLbl val="0"/>
      </c:catAx>
      <c:valAx>
        <c:axId val="37128753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712940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8395914483885184"/>
          <c:y val="1.6308489853101599E-2"/>
          <c:w val="0.1248289171270361"/>
          <c:h val="0.3686312618340887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 w="6350" cap="flat" cmpd="sng" algn="ctr">
      <a:noFill/>
      <a:prstDash val="solid"/>
      <a:miter lim="800000"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407DA-8BB9-47E5-8294-AC78615BDFBB}" type="datetimeFigureOut">
              <a:rPr kumimoji="1" lang="ja-JP" altLang="en-US" smtClean="0"/>
              <a:t>2021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CDFDD-F8BD-4D00-BF6E-1ED121240E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2146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407DA-8BB9-47E5-8294-AC78615BDFBB}" type="datetimeFigureOut">
              <a:rPr kumimoji="1" lang="ja-JP" altLang="en-US" smtClean="0"/>
              <a:t>2021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CDFDD-F8BD-4D00-BF6E-1ED121240E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74855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407DA-8BB9-47E5-8294-AC78615BDFBB}" type="datetimeFigureOut">
              <a:rPr kumimoji="1" lang="ja-JP" altLang="en-US" smtClean="0"/>
              <a:t>2021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CDFDD-F8BD-4D00-BF6E-1ED121240E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0170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407DA-8BB9-47E5-8294-AC78615BDFBB}" type="datetimeFigureOut">
              <a:rPr kumimoji="1" lang="ja-JP" altLang="en-US" smtClean="0"/>
              <a:t>2021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CDFDD-F8BD-4D00-BF6E-1ED121240E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1790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407DA-8BB9-47E5-8294-AC78615BDFBB}" type="datetimeFigureOut">
              <a:rPr kumimoji="1" lang="ja-JP" altLang="en-US" smtClean="0"/>
              <a:t>2021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CDFDD-F8BD-4D00-BF6E-1ED121240E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80953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407DA-8BB9-47E5-8294-AC78615BDFBB}" type="datetimeFigureOut">
              <a:rPr kumimoji="1" lang="ja-JP" altLang="en-US" smtClean="0"/>
              <a:t>2021/1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CDFDD-F8BD-4D00-BF6E-1ED121240E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56603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407DA-8BB9-47E5-8294-AC78615BDFBB}" type="datetimeFigureOut">
              <a:rPr kumimoji="1" lang="ja-JP" altLang="en-US" smtClean="0"/>
              <a:t>2021/11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CDFDD-F8BD-4D00-BF6E-1ED121240E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2281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407DA-8BB9-47E5-8294-AC78615BDFBB}" type="datetimeFigureOut">
              <a:rPr kumimoji="1" lang="ja-JP" altLang="en-US" smtClean="0"/>
              <a:t>2021/11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CDFDD-F8BD-4D00-BF6E-1ED121240E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49568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407DA-8BB9-47E5-8294-AC78615BDFBB}" type="datetimeFigureOut">
              <a:rPr kumimoji="1" lang="ja-JP" altLang="en-US" smtClean="0"/>
              <a:t>2021/11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CDFDD-F8BD-4D00-BF6E-1ED121240E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51073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407DA-8BB9-47E5-8294-AC78615BDFBB}" type="datetimeFigureOut">
              <a:rPr kumimoji="1" lang="ja-JP" altLang="en-US" smtClean="0"/>
              <a:t>2021/1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CDFDD-F8BD-4D00-BF6E-1ED121240E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37340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407DA-8BB9-47E5-8294-AC78615BDFBB}" type="datetimeFigureOut">
              <a:rPr kumimoji="1" lang="ja-JP" altLang="en-US" smtClean="0"/>
              <a:t>2021/11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CDFDD-F8BD-4D00-BF6E-1ED121240E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92497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C407DA-8BB9-47E5-8294-AC78615BDFBB}" type="datetimeFigureOut">
              <a:rPr kumimoji="1" lang="ja-JP" altLang="en-US" smtClean="0"/>
              <a:t>2021/11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2CDFDD-F8BD-4D00-BF6E-1ED121240E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4131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="" xmlns:xdr="http://schemas.openxmlformats.org/drawingml/2006/spreadsheetDrawing" xmlns:a16="http://schemas.microsoft.com/office/drawing/2014/main" xmlns:lc="http://schemas.openxmlformats.org/drawingml/2006/lockedCanvas" id="{00000000-0008-0000-03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0236777"/>
              </p:ext>
            </p:extLst>
          </p:nvPr>
        </p:nvGraphicFramePr>
        <p:xfrm>
          <a:off x="4638394" y="1614874"/>
          <a:ext cx="4452359" cy="32474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="" xmlns:xdr="http://schemas.openxmlformats.org/drawingml/2006/spreadsheetDrawing" xmlns:a16="http://schemas.microsoft.com/office/drawing/2014/main" xmlns:lc="http://schemas.openxmlformats.org/drawingml/2006/lockedCanvas" id="{3142D85D-061F-4621-AC59-2C092895217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8542029"/>
              </p:ext>
            </p:extLst>
          </p:nvPr>
        </p:nvGraphicFramePr>
        <p:xfrm>
          <a:off x="-108102" y="1266092"/>
          <a:ext cx="5612153" cy="3382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472272" y="622997"/>
            <a:ext cx="336619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  Carbon related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49190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="" xmlns:xdr="http://schemas.openxmlformats.org/drawingml/2006/spreadsheetDrawing" xmlns:a16="http://schemas.microsoft.com/office/drawing/2014/main" xmlns:lc="http://schemas.openxmlformats.org/drawingml/2006/lockedCanvas" id="{94BF5B3B-6DC7-46AE-AEFE-0CA850663E1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03357531"/>
              </p:ext>
            </p:extLst>
          </p:nvPr>
        </p:nvGraphicFramePr>
        <p:xfrm>
          <a:off x="4551903" y="1276138"/>
          <a:ext cx="4464167" cy="41399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="" xmlns:xdr="http://schemas.openxmlformats.org/drawingml/2006/spreadsheetDrawing" xmlns:a16="http://schemas.microsoft.com/office/drawing/2014/main" xmlns:lc="http://schemas.openxmlformats.org/drawingml/2006/lockedCanvas" id="{CBDD29DD-064F-4A7F-B979-9BE14ACD503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45138283"/>
              </p:ext>
            </p:extLst>
          </p:nvPr>
        </p:nvGraphicFramePr>
        <p:xfrm>
          <a:off x="117698" y="1320935"/>
          <a:ext cx="4494496" cy="33655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472272" y="622997"/>
            <a:ext cx="369779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)  Nitrogen related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57457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グラフ 6">
            <a:extLst>
              <a:ext uri="{FF2B5EF4-FFF2-40B4-BE49-F238E27FC236}">
                <a16:creationId xmlns="" xmlns:xdr="http://schemas.openxmlformats.org/drawingml/2006/spreadsheetDrawing" xmlns:a16="http://schemas.microsoft.com/office/drawing/2014/main" xmlns:lc="http://schemas.openxmlformats.org/drawingml/2006/lockedCanvas" id="{359912A6-DF27-4400-A21E-8C15B47EC0F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7115366"/>
              </p:ext>
            </p:extLst>
          </p:nvPr>
        </p:nvGraphicFramePr>
        <p:xfrm>
          <a:off x="4461470" y="1184960"/>
          <a:ext cx="4734299" cy="39060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="" xmlns:xdr="http://schemas.openxmlformats.org/drawingml/2006/spreadsheetDrawing" xmlns:a16="http://schemas.microsoft.com/office/drawing/2014/main" xmlns:lc="http://schemas.openxmlformats.org/drawingml/2006/lockedCanvas" id="{5D9A10E1-4301-439C-B45D-DD423C1AE63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207533"/>
              </p:ext>
            </p:extLst>
          </p:nvPr>
        </p:nvGraphicFramePr>
        <p:xfrm>
          <a:off x="35006" y="1323663"/>
          <a:ext cx="4947945" cy="39737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テキスト ボックス 1"/>
          <p:cNvSpPr txBox="1"/>
          <p:nvPr/>
        </p:nvSpPr>
        <p:spPr>
          <a:xfrm>
            <a:off x="472272" y="622997"/>
            <a:ext cx="336619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)  Sulfur related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40279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46</TotalTime>
  <Words>12</Words>
  <Application>Microsoft Office PowerPoint</Application>
  <PresentationFormat>画面に合わせる (4:3)</PresentationFormat>
  <Paragraphs>3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足立亨介</dc:creator>
  <cp:lastModifiedBy>Owner</cp:lastModifiedBy>
  <cp:revision>4</cp:revision>
  <dcterms:created xsi:type="dcterms:W3CDTF">2020-03-05T05:06:29Z</dcterms:created>
  <dcterms:modified xsi:type="dcterms:W3CDTF">2021-11-04T08:12:42Z</dcterms:modified>
</cp:coreProperties>
</file>